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9" r:id="rId2"/>
  </p:sldIdLst>
  <p:sldSz cx="9144000" cy="6858000" type="screen4x3"/>
  <p:notesSz cx="7010400" cy="92964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588" autoAdjust="0"/>
    <p:restoredTop sz="95280" autoAdjust="0"/>
  </p:normalViewPr>
  <p:slideViewPr>
    <p:cSldViewPr snapToGrid="0">
      <p:cViewPr varScale="1">
        <p:scale>
          <a:sx n="82" d="100"/>
          <a:sy n="82" d="100"/>
        </p:scale>
        <p:origin x="1478" y="72"/>
      </p:cViewPr>
      <p:guideLst>
        <p:guide orient="horz" pos="2160"/>
        <p:guide pos="2880"/>
      </p:guideLst>
    </p:cSldViewPr>
  </p:slideViewPr>
  <p:outlineViewPr>
    <p:cViewPr>
      <p:scale>
        <a:sx n="33" d="100"/>
        <a:sy n="33" d="100"/>
      </p:scale>
      <p:origin x="0" y="0"/>
    </p:cViewPr>
  </p:outlin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fr-CH"/>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A7F6AEA7-7538-413F-942D-8ECB8A4E63E0}" type="datetimeFigureOut">
              <a:rPr lang="fr-CH" smtClean="0"/>
              <a:t>31.10.2023</a:t>
            </a:fld>
            <a:endParaRPr lang="fr-CH"/>
          </a:p>
        </p:txBody>
      </p:sp>
      <p:sp>
        <p:nvSpPr>
          <p:cNvPr id="4" name="Slide Image Placeholder 3"/>
          <p:cNvSpPr>
            <a:spLocks noGrp="1" noRot="1" noChangeAspect="1"/>
          </p:cNvSpPr>
          <p:nvPr>
            <p:ph type="sldImg" idx="2"/>
          </p:nvPr>
        </p:nvSpPr>
        <p:spPr>
          <a:xfrm>
            <a:off x="1414463" y="1162050"/>
            <a:ext cx="4181475" cy="3136900"/>
          </a:xfrm>
          <a:prstGeom prst="rect">
            <a:avLst/>
          </a:prstGeom>
          <a:noFill/>
          <a:ln w="12700">
            <a:solidFill>
              <a:prstClr val="black"/>
            </a:solidFill>
          </a:ln>
        </p:spPr>
        <p:txBody>
          <a:bodyPr vert="horz" lIns="93177" tIns="46589" rIns="93177" bIns="46589" rtlCol="0" anchor="ctr"/>
          <a:lstStyle/>
          <a:p>
            <a:endParaRPr lang="fr-CH"/>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CH"/>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fr-CH"/>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6569C9F0-90FE-43F9-95B6-33C9C358FC58}" type="slidenum">
              <a:rPr lang="fr-CH" smtClean="0"/>
              <a:t>‹#›</a:t>
            </a:fld>
            <a:endParaRPr lang="fr-CH"/>
          </a:p>
        </p:txBody>
      </p:sp>
    </p:spTree>
    <p:extLst>
      <p:ext uri="{BB962C8B-B14F-4D97-AF65-F5344CB8AC3E}">
        <p14:creationId xmlns:p14="http://schemas.microsoft.com/office/powerpoint/2010/main" val="21965571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414463" y="1162050"/>
            <a:ext cx="4181475" cy="3136900"/>
          </a:xfrm>
        </p:spPr>
      </p:sp>
      <p:sp>
        <p:nvSpPr>
          <p:cNvPr id="3" name="Notes Placeholder 2"/>
          <p:cNvSpPr>
            <a:spLocks noGrp="1"/>
          </p:cNvSpPr>
          <p:nvPr>
            <p:ph type="body" idx="1"/>
          </p:nvPr>
        </p:nvSpPr>
        <p:spPr/>
        <p:txBody>
          <a:bodyPr/>
          <a:lstStyle/>
          <a:p>
            <a:endParaRPr lang="ro-RO" dirty="0"/>
          </a:p>
        </p:txBody>
      </p:sp>
      <p:sp>
        <p:nvSpPr>
          <p:cNvPr id="4" name="Slide Number Placeholder 3"/>
          <p:cNvSpPr>
            <a:spLocks noGrp="1"/>
          </p:cNvSpPr>
          <p:nvPr>
            <p:ph type="sldNum" sz="quarter" idx="10"/>
          </p:nvPr>
        </p:nvSpPr>
        <p:spPr/>
        <p:txBody>
          <a:bodyPr/>
          <a:lstStyle/>
          <a:p>
            <a:fld id="{6569C9F0-90FE-43F9-95B6-33C9C358FC58}" type="slidenum">
              <a:rPr lang="fr-CH" smtClean="0"/>
              <a:t>1</a:t>
            </a:fld>
            <a:endParaRPr lang="fr-CH"/>
          </a:p>
        </p:txBody>
      </p:sp>
    </p:spTree>
    <p:extLst>
      <p:ext uri="{BB962C8B-B14F-4D97-AF65-F5344CB8AC3E}">
        <p14:creationId xmlns:p14="http://schemas.microsoft.com/office/powerpoint/2010/main" val="32018086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4683B30-7C30-4A3B-A0FF-EE3FD3E77BF5}" type="datetimeFigureOut">
              <a:rPr lang="fr-CH" smtClean="0"/>
              <a:t>31.10.2023</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102C61A9-5291-4956-A6E6-98F1A5982C7A}" type="slidenum">
              <a:rPr lang="fr-CH" smtClean="0"/>
              <a:t>‹#›</a:t>
            </a:fld>
            <a:endParaRPr lang="fr-CH"/>
          </a:p>
        </p:txBody>
      </p:sp>
    </p:spTree>
    <p:extLst>
      <p:ext uri="{BB962C8B-B14F-4D97-AF65-F5344CB8AC3E}">
        <p14:creationId xmlns:p14="http://schemas.microsoft.com/office/powerpoint/2010/main" val="12839668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83B30-7C30-4A3B-A0FF-EE3FD3E77BF5}" type="datetimeFigureOut">
              <a:rPr lang="fr-CH" smtClean="0"/>
              <a:t>31.10.2023</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102C61A9-5291-4956-A6E6-98F1A5982C7A}" type="slidenum">
              <a:rPr lang="fr-CH" smtClean="0"/>
              <a:t>‹#›</a:t>
            </a:fld>
            <a:endParaRPr lang="fr-CH"/>
          </a:p>
        </p:txBody>
      </p:sp>
    </p:spTree>
    <p:extLst>
      <p:ext uri="{BB962C8B-B14F-4D97-AF65-F5344CB8AC3E}">
        <p14:creationId xmlns:p14="http://schemas.microsoft.com/office/powerpoint/2010/main" val="5615639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83B30-7C30-4A3B-A0FF-EE3FD3E77BF5}" type="datetimeFigureOut">
              <a:rPr lang="fr-CH" smtClean="0"/>
              <a:t>31.10.2023</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102C61A9-5291-4956-A6E6-98F1A5982C7A}" type="slidenum">
              <a:rPr lang="fr-CH" smtClean="0"/>
              <a:t>‹#›</a:t>
            </a:fld>
            <a:endParaRPr lang="fr-CH"/>
          </a:p>
        </p:txBody>
      </p:sp>
    </p:spTree>
    <p:extLst>
      <p:ext uri="{BB962C8B-B14F-4D97-AF65-F5344CB8AC3E}">
        <p14:creationId xmlns:p14="http://schemas.microsoft.com/office/powerpoint/2010/main" val="20890677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83B30-7C30-4A3B-A0FF-EE3FD3E77BF5}" type="datetimeFigureOut">
              <a:rPr lang="fr-CH" smtClean="0"/>
              <a:t>31.10.2023</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102C61A9-5291-4956-A6E6-98F1A5982C7A}" type="slidenum">
              <a:rPr lang="fr-CH" smtClean="0"/>
              <a:t>‹#›</a:t>
            </a:fld>
            <a:endParaRPr lang="fr-CH"/>
          </a:p>
        </p:txBody>
      </p:sp>
    </p:spTree>
    <p:extLst>
      <p:ext uri="{BB962C8B-B14F-4D97-AF65-F5344CB8AC3E}">
        <p14:creationId xmlns:p14="http://schemas.microsoft.com/office/powerpoint/2010/main" val="1950487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683B30-7C30-4A3B-A0FF-EE3FD3E77BF5}" type="datetimeFigureOut">
              <a:rPr lang="fr-CH" smtClean="0"/>
              <a:t>31.10.2023</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102C61A9-5291-4956-A6E6-98F1A5982C7A}" type="slidenum">
              <a:rPr lang="fr-CH" smtClean="0"/>
              <a:t>‹#›</a:t>
            </a:fld>
            <a:endParaRPr lang="fr-CH"/>
          </a:p>
        </p:txBody>
      </p:sp>
    </p:spTree>
    <p:extLst>
      <p:ext uri="{BB962C8B-B14F-4D97-AF65-F5344CB8AC3E}">
        <p14:creationId xmlns:p14="http://schemas.microsoft.com/office/powerpoint/2010/main" val="26995810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4683B30-7C30-4A3B-A0FF-EE3FD3E77BF5}" type="datetimeFigureOut">
              <a:rPr lang="fr-CH" smtClean="0"/>
              <a:t>31.10.2023</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102C61A9-5291-4956-A6E6-98F1A5982C7A}" type="slidenum">
              <a:rPr lang="fr-CH" smtClean="0"/>
              <a:t>‹#›</a:t>
            </a:fld>
            <a:endParaRPr lang="fr-CH"/>
          </a:p>
        </p:txBody>
      </p:sp>
    </p:spTree>
    <p:extLst>
      <p:ext uri="{BB962C8B-B14F-4D97-AF65-F5344CB8AC3E}">
        <p14:creationId xmlns:p14="http://schemas.microsoft.com/office/powerpoint/2010/main" val="12952820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4683B30-7C30-4A3B-A0FF-EE3FD3E77BF5}" type="datetimeFigureOut">
              <a:rPr lang="fr-CH" smtClean="0"/>
              <a:t>31.10.2023</a:t>
            </a:fld>
            <a:endParaRPr lang="fr-CH"/>
          </a:p>
        </p:txBody>
      </p:sp>
      <p:sp>
        <p:nvSpPr>
          <p:cNvPr id="8" name="Footer Placeholder 7"/>
          <p:cNvSpPr>
            <a:spLocks noGrp="1"/>
          </p:cNvSpPr>
          <p:nvPr>
            <p:ph type="ftr" sz="quarter" idx="11"/>
          </p:nvPr>
        </p:nvSpPr>
        <p:spPr/>
        <p:txBody>
          <a:bodyPr/>
          <a:lstStyle/>
          <a:p>
            <a:endParaRPr lang="fr-CH"/>
          </a:p>
        </p:txBody>
      </p:sp>
      <p:sp>
        <p:nvSpPr>
          <p:cNvPr id="9" name="Slide Number Placeholder 8"/>
          <p:cNvSpPr>
            <a:spLocks noGrp="1"/>
          </p:cNvSpPr>
          <p:nvPr>
            <p:ph type="sldNum" sz="quarter" idx="12"/>
          </p:nvPr>
        </p:nvSpPr>
        <p:spPr/>
        <p:txBody>
          <a:bodyPr/>
          <a:lstStyle/>
          <a:p>
            <a:fld id="{102C61A9-5291-4956-A6E6-98F1A5982C7A}" type="slidenum">
              <a:rPr lang="fr-CH" smtClean="0"/>
              <a:t>‹#›</a:t>
            </a:fld>
            <a:endParaRPr lang="fr-CH"/>
          </a:p>
        </p:txBody>
      </p:sp>
    </p:spTree>
    <p:extLst>
      <p:ext uri="{BB962C8B-B14F-4D97-AF65-F5344CB8AC3E}">
        <p14:creationId xmlns:p14="http://schemas.microsoft.com/office/powerpoint/2010/main" val="9731556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4683B30-7C30-4A3B-A0FF-EE3FD3E77BF5}" type="datetimeFigureOut">
              <a:rPr lang="fr-CH" smtClean="0"/>
              <a:t>31.10.2023</a:t>
            </a:fld>
            <a:endParaRPr lang="fr-CH"/>
          </a:p>
        </p:txBody>
      </p:sp>
      <p:sp>
        <p:nvSpPr>
          <p:cNvPr id="4" name="Footer Placeholder 3"/>
          <p:cNvSpPr>
            <a:spLocks noGrp="1"/>
          </p:cNvSpPr>
          <p:nvPr>
            <p:ph type="ftr" sz="quarter" idx="11"/>
          </p:nvPr>
        </p:nvSpPr>
        <p:spPr/>
        <p:txBody>
          <a:bodyPr/>
          <a:lstStyle/>
          <a:p>
            <a:endParaRPr lang="fr-CH"/>
          </a:p>
        </p:txBody>
      </p:sp>
      <p:sp>
        <p:nvSpPr>
          <p:cNvPr id="5" name="Slide Number Placeholder 4"/>
          <p:cNvSpPr>
            <a:spLocks noGrp="1"/>
          </p:cNvSpPr>
          <p:nvPr>
            <p:ph type="sldNum" sz="quarter" idx="12"/>
          </p:nvPr>
        </p:nvSpPr>
        <p:spPr/>
        <p:txBody>
          <a:bodyPr/>
          <a:lstStyle/>
          <a:p>
            <a:fld id="{102C61A9-5291-4956-A6E6-98F1A5982C7A}" type="slidenum">
              <a:rPr lang="fr-CH" smtClean="0"/>
              <a:t>‹#›</a:t>
            </a:fld>
            <a:endParaRPr lang="fr-CH"/>
          </a:p>
        </p:txBody>
      </p:sp>
    </p:spTree>
    <p:extLst>
      <p:ext uri="{BB962C8B-B14F-4D97-AF65-F5344CB8AC3E}">
        <p14:creationId xmlns:p14="http://schemas.microsoft.com/office/powerpoint/2010/main" val="37068772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83B30-7C30-4A3B-A0FF-EE3FD3E77BF5}" type="datetimeFigureOut">
              <a:rPr lang="fr-CH" smtClean="0"/>
              <a:t>31.10.2023</a:t>
            </a:fld>
            <a:endParaRPr lang="fr-CH"/>
          </a:p>
        </p:txBody>
      </p:sp>
      <p:sp>
        <p:nvSpPr>
          <p:cNvPr id="3" name="Footer Placeholder 2"/>
          <p:cNvSpPr>
            <a:spLocks noGrp="1"/>
          </p:cNvSpPr>
          <p:nvPr>
            <p:ph type="ftr" sz="quarter" idx="11"/>
          </p:nvPr>
        </p:nvSpPr>
        <p:spPr/>
        <p:txBody>
          <a:bodyPr/>
          <a:lstStyle/>
          <a:p>
            <a:endParaRPr lang="fr-CH"/>
          </a:p>
        </p:txBody>
      </p:sp>
      <p:sp>
        <p:nvSpPr>
          <p:cNvPr id="4" name="Slide Number Placeholder 3"/>
          <p:cNvSpPr>
            <a:spLocks noGrp="1"/>
          </p:cNvSpPr>
          <p:nvPr>
            <p:ph type="sldNum" sz="quarter" idx="12"/>
          </p:nvPr>
        </p:nvSpPr>
        <p:spPr/>
        <p:txBody>
          <a:bodyPr/>
          <a:lstStyle/>
          <a:p>
            <a:fld id="{102C61A9-5291-4956-A6E6-98F1A5982C7A}" type="slidenum">
              <a:rPr lang="fr-CH" smtClean="0"/>
              <a:t>‹#›</a:t>
            </a:fld>
            <a:endParaRPr lang="fr-CH"/>
          </a:p>
        </p:txBody>
      </p:sp>
    </p:spTree>
    <p:extLst>
      <p:ext uri="{BB962C8B-B14F-4D97-AF65-F5344CB8AC3E}">
        <p14:creationId xmlns:p14="http://schemas.microsoft.com/office/powerpoint/2010/main" val="30431622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83B30-7C30-4A3B-A0FF-EE3FD3E77BF5}" type="datetimeFigureOut">
              <a:rPr lang="fr-CH" smtClean="0"/>
              <a:t>31.10.2023</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102C61A9-5291-4956-A6E6-98F1A5982C7A}" type="slidenum">
              <a:rPr lang="fr-CH" smtClean="0"/>
              <a:t>‹#›</a:t>
            </a:fld>
            <a:endParaRPr lang="fr-CH"/>
          </a:p>
        </p:txBody>
      </p:sp>
    </p:spTree>
    <p:extLst>
      <p:ext uri="{BB962C8B-B14F-4D97-AF65-F5344CB8AC3E}">
        <p14:creationId xmlns:p14="http://schemas.microsoft.com/office/powerpoint/2010/main" val="10274156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83B30-7C30-4A3B-A0FF-EE3FD3E77BF5}" type="datetimeFigureOut">
              <a:rPr lang="fr-CH" smtClean="0"/>
              <a:t>31.10.2023</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102C61A9-5291-4956-A6E6-98F1A5982C7A}" type="slidenum">
              <a:rPr lang="fr-CH" smtClean="0"/>
              <a:t>‹#›</a:t>
            </a:fld>
            <a:endParaRPr lang="fr-CH"/>
          </a:p>
        </p:txBody>
      </p:sp>
    </p:spTree>
    <p:extLst>
      <p:ext uri="{BB962C8B-B14F-4D97-AF65-F5344CB8AC3E}">
        <p14:creationId xmlns:p14="http://schemas.microsoft.com/office/powerpoint/2010/main" val="42027359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4683B30-7C30-4A3B-A0FF-EE3FD3E77BF5}" type="datetimeFigureOut">
              <a:rPr lang="fr-CH" smtClean="0"/>
              <a:t>31.10.2023</a:t>
            </a:fld>
            <a:endParaRPr lang="fr-CH"/>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CH"/>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02C61A9-5291-4956-A6E6-98F1A5982C7A}" type="slidenum">
              <a:rPr lang="fr-CH" smtClean="0"/>
              <a:t>‹#›</a:t>
            </a:fld>
            <a:endParaRPr lang="fr-CH"/>
          </a:p>
        </p:txBody>
      </p:sp>
    </p:spTree>
    <p:extLst>
      <p:ext uri="{BB962C8B-B14F-4D97-AF65-F5344CB8AC3E}">
        <p14:creationId xmlns:p14="http://schemas.microsoft.com/office/powerpoint/2010/main" val="181703483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7.xml"/><Relationship Id="rId1" Type="http://schemas.openxmlformats.org/officeDocument/2006/relationships/vmlDrawing" Target="../drawings/vmlDrawing1.vml"/><Relationship Id="rId5" Type="http://schemas.openxmlformats.org/officeDocument/2006/relationships/image" Target="../media/image1.emf"/><Relationship Id="rId4" Type="http://schemas.openxmlformats.org/officeDocument/2006/relationships/oleObject" Target="../embeddings/oleObject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1440273" y="662428"/>
            <a:ext cx="6137605" cy="4174331"/>
            <a:chOff x="1098550" y="341313"/>
            <a:chExt cx="8743950" cy="6138862"/>
          </a:xfrm>
        </p:grpSpPr>
        <p:sp>
          <p:nvSpPr>
            <p:cNvPr id="37" name="Rectangle 36"/>
            <p:cNvSpPr/>
            <p:nvPr/>
          </p:nvSpPr>
          <p:spPr>
            <a:xfrm>
              <a:off x="5552601" y="3617633"/>
              <a:ext cx="1009313" cy="1620649"/>
            </a:xfrm>
            <a:prstGeom prst="rect">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o-RO" sz="1350"/>
            </a:p>
          </p:txBody>
        </p:sp>
        <p:sp>
          <p:nvSpPr>
            <p:cNvPr id="36" name="Rectangle 35"/>
            <p:cNvSpPr/>
            <p:nvPr/>
          </p:nvSpPr>
          <p:spPr>
            <a:xfrm>
              <a:off x="5365717" y="5197955"/>
              <a:ext cx="1196196" cy="62221"/>
            </a:xfrm>
            <a:prstGeom prst="rect">
              <a:avLst/>
            </a:pr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o-RO" sz="1350"/>
            </a:p>
          </p:txBody>
        </p:sp>
        <p:sp>
          <p:nvSpPr>
            <p:cNvPr id="38" name="Freeform 37"/>
            <p:cNvSpPr/>
            <p:nvPr/>
          </p:nvSpPr>
          <p:spPr>
            <a:xfrm>
              <a:off x="5393476" y="1880483"/>
              <a:ext cx="1159724" cy="3351917"/>
            </a:xfrm>
            <a:custGeom>
              <a:avLst/>
              <a:gdLst>
                <a:gd name="connsiteX0" fmla="*/ 4024 w 1159724"/>
                <a:gd name="connsiteY0" fmla="*/ 3302000 h 3321050"/>
                <a:gd name="connsiteX1" fmla="*/ 29424 w 1159724"/>
                <a:gd name="connsiteY1" fmla="*/ 3232150 h 3321050"/>
                <a:gd name="connsiteX2" fmla="*/ 35774 w 1159724"/>
                <a:gd name="connsiteY2" fmla="*/ 3206750 h 3321050"/>
                <a:gd name="connsiteX3" fmla="*/ 48474 w 1159724"/>
                <a:gd name="connsiteY3" fmla="*/ 3168650 h 3321050"/>
                <a:gd name="connsiteX4" fmla="*/ 54824 w 1159724"/>
                <a:gd name="connsiteY4" fmla="*/ 3149600 h 3321050"/>
                <a:gd name="connsiteX5" fmla="*/ 61174 w 1159724"/>
                <a:gd name="connsiteY5" fmla="*/ 3117850 h 3321050"/>
                <a:gd name="connsiteX6" fmla="*/ 73874 w 1159724"/>
                <a:gd name="connsiteY6" fmla="*/ 3067050 h 3321050"/>
                <a:gd name="connsiteX7" fmla="*/ 80224 w 1159724"/>
                <a:gd name="connsiteY7" fmla="*/ 2952750 h 3321050"/>
                <a:gd name="connsiteX8" fmla="*/ 86574 w 1159724"/>
                <a:gd name="connsiteY8" fmla="*/ 2933700 h 3321050"/>
                <a:gd name="connsiteX9" fmla="*/ 92924 w 1159724"/>
                <a:gd name="connsiteY9" fmla="*/ 2711450 h 3321050"/>
                <a:gd name="connsiteX10" fmla="*/ 105624 w 1159724"/>
                <a:gd name="connsiteY10" fmla="*/ 2616200 h 3321050"/>
                <a:gd name="connsiteX11" fmla="*/ 111974 w 1159724"/>
                <a:gd name="connsiteY11" fmla="*/ 2590800 h 3321050"/>
                <a:gd name="connsiteX12" fmla="*/ 105624 w 1159724"/>
                <a:gd name="connsiteY12" fmla="*/ 2527300 h 3321050"/>
                <a:gd name="connsiteX13" fmla="*/ 118324 w 1159724"/>
                <a:gd name="connsiteY13" fmla="*/ 2432050 h 3321050"/>
                <a:gd name="connsiteX14" fmla="*/ 124674 w 1159724"/>
                <a:gd name="connsiteY14" fmla="*/ 2362200 h 3321050"/>
                <a:gd name="connsiteX15" fmla="*/ 131024 w 1159724"/>
                <a:gd name="connsiteY15" fmla="*/ 2324100 h 3321050"/>
                <a:gd name="connsiteX16" fmla="*/ 124674 w 1159724"/>
                <a:gd name="connsiteY16" fmla="*/ 2260600 h 3321050"/>
                <a:gd name="connsiteX17" fmla="*/ 137374 w 1159724"/>
                <a:gd name="connsiteY17" fmla="*/ 2127250 h 3321050"/>
                <a:gd name="connsiteX18" fmla="*/ 156424 w 1159724"/>
                <a:gd name="connsiteY18" fmla="*/ 2063750 h 3321050"/>
                <a:gd name="connsiteX19" fmla="*/ 162774 w 1159724"/>
                <a:gd name="connsiteY19" fmla="*/ 2044700 h 3321050"/>
                <a:gd name="connsiteX20" fmla="*/ 156424 w 1159724"/>
                <a:gd name="connsiteY20" fmla="*/ 2019300 h 3321050"/>
                <a:gd name="connsiteX21" fmla="*/ 169124 w 1159724"/>
                <a:gd name="connsiteY21" fmla="*/ 1930400 h 3321050"/>
                <a:gd name="connsiteX22" fmla="*/ 175474 w 1159724"/>
                <a:gd name="connsiteY22" fmla="*/ 1854200 h 3321050"/>
                <a:gd name="connsiteX23" fmla="*/ 188174 w 1159724"/>
                <a:gd name="connsiteY23" fmla="*/ 1644650 h 3321050"/>
                <a:gd name="connsiteX24" fmla="*/ 194524 w 1159724"/>
                <a:gd name="connsiteY24" fmla="*/ 1581150 h 3321050"/>
                <a:gd name="connsiteX25" fmla="*/ 188174 w 1159724"/>
                <a:gd name="connsiteY25" fmla="*/ 1498600 h 3321050"/>
                <a:gd name="connsiteX26" fmla="*/ 200874 w 1159724"/>
                <a:gd name="connsiteY26" fmla="*/ 1403350 h 3321050"/>
                <a:gd name="connsiteX27" fmla="*/ 207224 w 1159724"/>
                <a:gd name="connsiteY27" fmla="*/ 1257300 h 3321050"/>
                <a:gd name="connsiteX28" fmla="*/ 213574 w 1159724"/>
                <a:gd name="connsiteY28" fmla="*/ 1238250 h 3321050"/>
                <a:gd name="connsiteX29" fmla="*/ 226274 w 1159724"/>
                <a:gd name="connsiteY29" fmla="*/ 1168400 h 3321050"/>
                <a:gd name="connsiteX30" fmla="*/ 232624 w 1159724"/>
                <a:gd name="connsiteY30" fmla="*/ 1104900 h 3321050"/>
                <a:gd name="connsiteX31" fmla="*/ 245324 w 1159724"/>
                <a:gd name="connsiteY31" fmla="*/ 1041400 h 3321050"/>
                <a:gd name="connsiteX32" fmla="*/ 251674 w 1159724"/>
                <a:gd name="connsiteY32" fmla="*/ 1003300 h 3321050"/>
                <a:gd name="connsiteX33" fmla="*/ 251674 w 1159724"/>
                <a:gd name="connsiteY33" fmla="*/ 958850 h 3321050"/>
                <a:gd name="connsiteX34" fmla="*/ 264374 w 1159724"/>
                <a:gd name="connsiteY34" fmla="*/ 869950 h 3321050"/>
                <a:gd name="connsiteX35" fmla="*/ 270724 w 1159724"/>
                <a:gd name="connsiteY35" fmla="*/ 812800 h 3321050"/>
                <a:gd name="connsiteX36" fmla="*/ 277074 w 1159724"/>
                <a:gd name="connsiteY36" fmla="*/ 793750 h 3321050"/>
                <a:gd name="connsiteX37" fmla="*/ 270724 w 1159724"/>
                <a:gd name="connsiteY37" fmla="*/ 762000 h 3321050"/>
                <a:gd name="connsiteX38" fmla="*/ 277074 w 1159724"/>
                <a:gd name="connsiteY38" fmla="*/ 736600 h 3321050"/>
                <a:gd name="connsiteX39" fmla="*/ 289774 w 1159724"/>
                <a:gd name="connsiteY39" fmla="*/ 717550 h 3321050"/>
                <a:gd name="connsiteX40" fmla="*/ 296124 w 1159724"/>
                <a:gd name="connsiteY40" fmla="*/ 673100 h 3321050"/>
                <a:gd name="connsiteX41" fmla="*/ 302474 w 1159724"/>
                <a:gd name="connsiteY41" fmla="*/ 635000 h 3321050"/>
                <a:gd name="connsiteX42" fmla="*/ 308824 w 1159724"/>
                <a:gd name="connsiteY42" fmla="*/ 565150 h 3321050"/>
                <a:gd name="connsiteX43" fmla="*/ 321524 w 1159724"/>
                <a:gd name="connsiteY43" fmla="*/ 463550 h 3321050"/>
                <a:gd name="connsiteX44" fmla="*/ 334224 w 1159724"/>
                <a:gd name="connsiteY44" fmla="*/ 406400 h 3321050"/>
                <a:gd name="connsiteX45" fmla="*/ 340574 w 1159724"/>
                <a:gd name="connsiteY45" fmla="*/ 317500 h 3321050"/>
                <a:gd name="connsiteX46" fmla="*/ 353274 w 1159724"/>
                <a:gd name="connsiteY46" fmla="*/ 273050 h 3321050"/>
                <a:gd name="connsiteX47" fmla="*/ 372324 w 1159724"/>
                <a:gd name="connsiteY47" fmla="*/ 266700 h 3321050"/>
                <a:gd name="connsiteX48" fmla="*/ 410424 w 1159724"/>
                <a:gd name="connsiteY48" fmla="*/ 247650 h 3321050"/>
                <a:gd name="connsiteX49" fmla="*/ 423124 w 1159724"/>
                <a:gd name="connsiteY49" fmla="*/ 228600 h 3321050"/>
                <a:gd name="connsiteX50" fmla="*/ 442174 w 1159724"/>
                <a:gd name="connsiteY50" fmla="*/ 215900 h 3321050"/>
                <a:gd name="connsiteX51" fmla="*/ 448524 w 1159724"/>
                <a:gd name="connsiteY51" fmla="*/ 196850 h 3321050"/>
                <a:gd name="connsiteX52" fmla="*/ 461224 w 1159724"/>
                <a:gd name="connsiteY52" fmla="*/ 177800 h 3321050"/>
                <a:gd name="connsiteX53" fmla="*/ 473924 w 1159724"/>
                <a:gd name="connsiteY53" fmla="*/ 139700 h 3321050"/>
                <a:gd name="connsiteX54" fmla="*/ 499324 w 1159724"/>
                <a:gd name="connsiteY54" fmla="*/ 133350 h 3321050"/>
                <a:gd name="connsiteX55" fmla="*/ 518374 w 1159724"/>
                <a:gd name="connsiteY55" fmla="*/ 146050 h 3321050"/>
                <a:gd name="connsiteX56" fmla="*/ 537424 w 1159724"/>
                <a:gd name="connsiteY56" fmla="*/ 152400 h 3321050"/>
                <a:gd name="connsiteX57" fmla="*/ 575524 w 1159724"/>
                <a:gd name="connsiteY57" fmla="*/ 177800 h 3321050"/>
                <a:gd name="connsiteX58" fmla="*/ 594574 w 1159724"/>
                <a:gd name="connsiteY58" fmla="*/ 133350 h 3321050"/>
                <a:gd name="connsiteX59" fmla="*/ 613624 w 1159724"/>
                <a:gd name="connsiteY59" fmla="*/ 120650 h 3321050"/>
                <a:gd name="connsiteX60" fmla="*/ 619974 w 1159724"/>
                <a:gd name="connsiteY60" fmla="*/ 95250 h 3321050"/>
                <a:gd name="connsiteX61" fmla="*/ 664424 w 1159724"/>
                <a:gd name="connsiteY61" fmla="*/ 44450 h 3321050"/>
                <a:gd name="connsiteX62" fmla="*/ 683474 w 1159724"/>
                <a:gd name="connsiteY62" fmla="*/ 38100 h 3321050"/>
                <a:gd name="connsiteX63" fmla="*/ 721574 w 1159724"/>
                <a:gd name="connsiteY63" fmla="*/ 31750 h 3321050"/>
                <a:gd name="connsiteX64" fmla="*/ 734274 w 1159724"/>
                <a:gd name="connsiteY64" fmla="*/ 12700 h 3321050"/>
                <a:gd name="connsiteX65" fmla="*/ 772374 w 1159724"/>
                <a:gd name="connsiteY65" fmla="*/ 0 h 3321050"/>
                <a:gd name="connsiteX66" fmla="*/ 778724 w 1159724"/>
                <a:gd name="connsiteY66" fmla="*/ 19050 h 3321050"/>
                <a:gd name="connsiteX67" fmla="*/ 791424 w 1159724"/>
                <a:gd name="connsiteY67" fmla="*/ 38100 h 3321050"/>
                <a:gd name="connsiteX68" fmla="*/ 797774 w 1159724"/>
                <a:gd name="connsiteY68" fmla="*/ 76200 h 3321050"/>
                <a:gd name="connsiteX69" fmla="*/ 810474 w 1159724"/>
                <a:gd name="connsiteY69" fmla="*/ 114300 h 3321050"/>
                <a:gd name="connsiteX70" fmla="*/ 816824 w 1159724"/>
                <a:gd name="connsiteY70" fmla="*/ 184150 h 3321050"/>
                <a:gd name="connsiteX71" fmla="*/ 823174 w 1159724"/>
                <a:gd name="connsiteY71" fmla="*/ 203200 h 3321050"/>
                <a:gd name="connsiteX72" fmla="*/ 835874 w 1159724"/>
                <a:gd name="connsiteY72" fmla="*/ 285750 h 3321050"/>
                <a:gd name="connsiteX73" fmla="*/ 848574 w 1159724"/>
                <a:gd name="connsiteY73" fmla="*/ 323850 h 3321050"/>
                <a:gd name="connsiteX74" fmla="*/ 854924 w 1159724"/>
                <a:gd name="connsiteY74" fmla="*/ 342900 h 3321050"/>
                <a:gd name="connsiteX75" fmla="*/ 861274 w 1159724"/>
                <a:gd name="connsiteY75" fmla="*/ 374650 h 3321050"/>
                <a:gd name="connsiteX76" fmla="*/ 867624 w 1159724"/>
                <a:gd name="connsiteY76" fmla="*/ 412750 h 3321050"/>
                <a:gd name="connsiteX77" fmla="*/ 873974 w 1159724"/>
                <a:gd name="connsiteY77" fmla="*/ 438150 h 3321050"/>
                <a:gd name="connsiteX78" fmla="*/ 880324 w 1159724"/>
                <a:gd name="connsiteY78" fmla="*/ 469900 h 3321050"/>
                <a:gd name="connsiteX79" fmla="*/ 899374 w 1159724"/>
                <a:gd name="connsiteY79" fmla="*/ 546100 h 3321050"/>
                <a:gd name="connsiteX80" fmla="*/ 905724 w 1159724"/>
                <a:gd name="connsiteY80" fmla="*/ 641350 h 3321050"/>
                <a:gd name="connsiteX81" fmla="*/ 918424 w 1159724"/>
                <a:gd name="connsiteY81" fmla="*/ 679450 h 3321050"/>
                <a:gd name="connsiteX82" fmla="*/ 931124 w 1159724"/>
                <a:gd name="connsiteY82" fmla="*/ 723900 h 3321050"/>
                <a:gd name="connsiteX83" fmla="*/ 950174 w 1159724"/>
                <a:gd name="connsiteY83" fmla="*/ 882650 h 3321050"/>
                <a:gd name="connsiteX84" fmla="*/ 950174 w 1159724"/>
                <a:gd name="connsiteY84" fmla="*/ 882650 h 3321050"/>
                <a:gd name="connsiteX85" fmla="*/ 956524 w 1159724"/>
                <a:gd name="connsiteY85" fmla="*/ 908050 h 3321050"/>
                <a:gd name="connsiteX86" fmla="*/ 969224 w 1159724"/>
                <a:gd name="connsiteY86" fmla="*/ 946150 h 3321050"/>
                <a:gd name="connsiteX87" fmla="*/ 975574 w 1159724"/>
                <a:gd name="connsiteY87" fmla="*/ 1016000 h 3321050"/>
                <a:gd name="connsiteX88" fmla="*/ 988274 w 1159724"/>
                <a:gd name="connsiteY88" fmla="*/ 1054100 h 3321050"/>
                <a:gd name="connsiteX89" fmla="*/ 1020024 w 1159724"/>
                <a:gd name="connsiteY89" fmla="*/ 1149350 h 3321050"/>
                <a:gd name="connsiteX90" fmla="*/ 1039074 w 1159724"/>
                <a:gd name="connsiteY90" fmla="*/ 1206500 h 3321050"/>
                <a:gd name="connsiteX91" fmla="*/ 1045424 w 1159724"/>
                <a:gd name="connsiteY91" fmla="*/ 1225550 h 3321050"/>
                <a:gd name="connsiteX92" fmla="*/ 1051774 w 1159724"/>
                <a:gd name="connsiteY92" fmla="*/ 1244600 h 3321050"/>
                <a:gd name="connsiteX93" fmla="*/ 1064474 w 1159724"/>
                <a:gd name="connsiteY93" fmla="*/ 1358900 h 3321050"/>
                <a:gd name="connsiteX94" fmla="*/ 1077174 w 1159724"/>
                <a:gd name="connsiteY94" fmla="*/ 1397000 h 3321050"/>
                <a:gd name="connsiteX95" fmla="*/ 1083524 w 1159724"/>
                <a:gd name="connsiteY95" fmla="*/ 1441450 h 3321050"/>
                <a:gd name="connsiteX96" fmla="*/ 1096224 w 1159724"/>
                <a:gd name="connsiteY96" fmla="*/ 1479550 h 3321050"/>
                <a:gd name="connsiteX97" fmla="*/ 1115274 w 1159724"/>
                <a:gd name="connsiteY97" fmla="*/ 1555750 h 3321050"/>
                <a:gd name="connsiteX98" fmla="*/ 1121624 w 1159724"/>
                <a:gd name="connsiteY98" fmla="*/ 1574800 h 3321050"/>
                <a:gd name="connsiteX99" fmla="*/ 1134324 w 1159724"/>
                <a:gd name="connsiteY99" fmla="*/ 1593850 h 3321050"/>
                <a:gd name="connsiteX100" fmla="*/ 1140674 w 1159724"/>
                <a:gd name="connsiteY100" fmla="*/ 1644650 h 3321050"/>
                <a:gd name="connsiteX101" fmla="*/ 1147024 w 1159724"/>
                <a:gd name="connsiteY101" fmla="*/ 1663700 h 3321050"/>
                <a:gd name="connsiteX102" fmla="*/ 1159724 w 1159724"/>
                <a:gd name="connsiteY102" fmla="*/ 1720850 h 3321050"/>
                <a:gd name="connsiteX103" fmla="*/ 1153374 w 1159724"/>
                <a:gd name="connsiteY103" fmla="*/ 1746250 h 3321050"/>
                <a:gd name="connsiteX104" fmla="*/ 1134324 w 1159724"/>
                <a:gd name="connsiteY104" fmla="*/ 1784350 h 3321050"/>
                <a:gd name="connsiteX105" fmla="*/ 1115274 w 1159724"/>
                <a:gd name="connsiteY105" fmla="*/ 1797050 h 3321050"/>
                <a:gd name="connsiteX106" fmla="*/ 1108924 w 1159724"/>
                <a:gd name="connsiteY106" fmla="*/ 1816100 h 3321050"/>
                <a:gd name="connsiteX107" fmla="*/ 1064474 w 1159724"/>
                <a:gd name="connsiteY107" fmla="*/ 1873250 h 3321050"/>
                <a:gd name="connsiteX108" fmla="*/ 1039074 w 1159724"/>
                <a:gd name="connsiteY108" fmla="*/ 1930400 h 3321050"/>
                <a:gd name="connsiteX109" fmla="*/ 1007324 w 1159724"/>
                <a:gd name="connsiteY109" fmla="*/ 1968500 h 3321050"/>
                <a:gd name="connsiteX110" fmla="*/ 1000974 w 1159724"/>
                <a:gd name="connsiteY110" fmla="*/ 1987550 h 3321050"/>
                <a:gd name="connsiteX111" fmla="*/ 981924 w 1159724"/>
                <a:gd name="connsiteY111" fmla="*/ 2006600 h 3321050"/>
                <a:gd name="connsiteX112" fmla="*/ 969224 w 1159724"/>
                <a:gd name="connsiteY112" fmla="*/ 2025650 h 3321050"/>
                <a:gd name="connsiteX113" fmla="*/ 924774 w 1159724"/>
                <a:gd name="connsiteY113" fmla="*/ 2082800 h 3321050"/>
                <a:gd name="connsiteX114" fmla="*/ 905724 w 1159724"/>
                <a:gd name="connsiteY114" fmla="*/ 2120900 h 3321050"/>
                <a:gd name="connsiteX115" fmla="*/ 899374 w 1159724"/>
                <a:gd name="connsiteY115" fmla="*/ 2139950 h 3321050"/>
                <a:gd name="connsiteX116" fmla="*/ 873974 w 1159724"/>
                <a:gd name="connsiteY116" fmla="*/ 2178050 h 3321050"/>
                <a:gd name="connsiteX117" fmla="*/ 867624 w 1159724"/>
                <a:gd name="connsiteY117" fmla="*/ 2197100 h 3321050"/>
                <a:gd name="connsiteX118" fmla="*/ 842224 w 1159724"/>
                <a:gd name="connsiteY118" fmla="*/ 2235200 h 3321050"/>
                <a:gd name="connsiteX119" fmla="*/ 835874 w 1159724"/>
                <a:gd name="connsiteY119" fmla="*/ 2254250 h 3321050"/>
                <a:gd name="connsiteX120" fmla="*/ 810474 w 1159724"/>
                <a:gd name="connsiteY120" fmla="*/ 2292350 h 3321050"/>
                <a:gd name="connsiteX121" fmla="*/ 791424 w 1159724"/>
                <a:gd name="connsiteY121" fmla="*/ 2330450 h 3321050"/>
                <a:gd name="connsiteX122" fmla="*/ 785074 w 1159724"/>
                <a:gd name="connsiteY122" fmla="*/ 2349500 h 3321050"/>
                <a:gd name="connsiteX123" fmla="*/ 759674 w 1159724"/>
                <a:gd name="connsiteY123" fmla="*/ 2387600 h 3321050"/>
                <a:gd name="connsiteX124" fmla="*/ 746974 w 1159724"/>
                <a:gd name="connsiteY124" fmla="*/ 2406650 h 3321050"/>
                <a:gd name="connsiteX125" fmla="*/ 734274 w 1159724"/>
                <a:gd name="connsiteY125" fmla="*/ 2425700 h 3321050"/>
                <a:gd name="connsiteX126" fmla="*/ 715224 w 1159724"/>
                <a:gd name="connsiteY126" fmla="*/ 2444750 h 3321050"/>
                <a:gd name="connsiteX127" fmla="*/ 689824 w 1159724"/>
                <a:gd name="connsiteY127" fmla="*/ 2482850 h 3321050"/>
                <a:gd name="connsiteX128" fmla="*/ 664424 w 1159724"/>
                <a:gd name="connsiteY128" fmla="*/ 2520950 h 3321050"/>
                <a:gd name="connsiteX129" fmla="*/ 651724 w 1159724"/>
                <a:gd name="connsiteY129" fmla="*/ 2540000 h 3321050"/>
                <a:gd name="connsiteX130" fmla="*/ 639024 w 1159724"/>
                <a:gd name="connsiteY130" fmla="*/ 2559050 h 3321050"/>
                <a:gd name="connsiteX131" fmla="*/ 619974 w 1159724"/>
                <a:gd name="connsiteY131" fmla="*/ 2578100 h 3321050"/>
                <a:gd name="connsiteX132" fmla="*/ 588224 w 1159724"/>
                <a:gd name="connsiteY132" fmla="*/ 2609850 h 3321050"/>
                <a:gd name="connsiteX133" fmla="*/ 575524 w 1159724"/>
                <a:gd name="connsiteY133" fmla="*/ 2628900 h 3321050"/>
                <a:gd name="connsiteX134" fmla="*/ 556474 w 1159724"/>
                <a:gd name="connsiteY134" fmla="*/ 2647950 h 3321050"/>
                <a:gd name="connsiteX135" fmla="*/ 550124 w 1159724"/>
                <a:gd name="connsiteY135" fmla="*/ 2667000 h 3321050"/>
                <a:gd name="connsiteX136" fmla="*/ 524724 w 1159724"/>
                <a:gd name="connsiteY136" fmla="*/ 2705100 h 3321050"/>
                <a:gd name="connsiteX137" fmla="*/ 512024 w 1159724"/>
                <a:gd name="connsiteY137" fmla="*/ 2743200 h 3321050"/>
                <a:gd name="connsiteX138" fmla="*/ 492974 w 1159724"/>
                <a:gd name="connsiteY138" fmla="*/ 2781300 h 3321050"/>
                <a:gd name="connsiteX139" fmla="*/ 480274 w 1159724"/>
                <a:gd name="connsiteY139" fmla="*/ 2800350 h 3321050"/>
                <a:gd name="connsiteX140" fmla="*/ 467574 w 1159724"/>
                <a:gd name="connsiteY140" fmla="*/ 2838450 h 3321050"/>
                <a:gd name="connsiteX141" fmla="*/ 454874 w 1159724"/>
                <a:gd name="connsiteY141" fmla="*/ 2876550 h 3321050"/>
                <a:gd name="connsiteX142" fmla="*/ 448524 w 1159724"/>
                <a:gd name="connsiteY142" fmla="*/ 2895600 h 3321050"/>
                <a:gd name="connsiteX143" fmla="*/ 429474 w 1159724"/>
                <a:gd name="connsiteY143" fmla="*/ 2933700 h 3321050"/>
                <a:gd name="connsiteX144" fmla="*/ 416774 w 1159724"/>
                <a:gd name="connsiteY144" fmla="*/ 2952750 h 3321050"/>
                <a:gd name="connsiteX145" fmla="*/ 410424 w 1159724"/>
                <a:gd name="connsiteY145" fmla="*/ 2971800 h 3321050"/>
                <a:gd name="connsiteX146" fmla="*/ 365974 w 1159724"/>
                <a:gd name="connsiteY146" fmla="*/ 3022600 h 3321050"/>
                <a:gd name="connsiteX147" fmla="*/ 359624 w 1159724"/>
                <a:gd name="connsiteY147" fmla="*/ 3041650 h 3321050"/>
                <a:gd name="connsiteX148" fmla="*/ 334224 w 1159724"/>
                <a:gd name="connsiteY148" fmla="*/ 3079750 h 3321050"/>
                <a:gd name="connsiteX149" fmla="*/ 315174 w 1159724"/>
                <a:gd name="connsiteY149" fmla="*/ 3117850 h 3321050"/>
                <a:gd name="connsiteX150" fmla="*/ 308824 w 1159724"/>
                <a:gd name="connsiteY150" fmla="*/ 3136900 h 3321050"/>
                <a:gd name="connsiteX151" fmla="*/ 283424 w 1159724"/>
                <a:gd name="connsiteY151" fmla="*/ 3175000 h 3321050"/>
                <a:gd name="connsiteX152" fmla="*/ 270724 w 1159724"/>
                <a:gd name="connsiteY152" fmla="*/ 3194050 h 3321050"/>
                <a:gd name="connsiteX153" fmla="*/ 238974 w 1159724"/>
                <a:gd name="connsiteY153" fmla="*/ 3251200 h 3321050"/>
                <a:gd name="connsiteX154" fmla="*/ 226274 w 1159724"/>
                <a:gd name="connsiteY154" fmla="*/ 3270250 h 3321050"/>
                <a:gd name="connsiteX155" fmla="*/ 188174 w 1159724"/>
                <a:gd name="connsiteY155" fmla="*/ 3289300 h 3321050"/>
                <a:gd name="connsiteX156" fmla="*/ 175474 w 1159724"/>
                <a:gd name="connsiteY156" fmla="*/ 3308350 h 3321050"/>
                <a:gd name="connsiteX157" fmla="*/ 124674 w 1159724"/>
                <a:gd name="connsiteY157" fmla="*/ 3321050 h 3321050"/>
                <a:gd name="connsiteX158" fmla="*/ 4024 w 1159724"/>
                <a:gd name="connsiteY158" fmla="*/ 3302000 h 33210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Lst>
              <a:rect l="l" t="t" r="r" b="b"/>
              <a:pathLst>
                <a:path w="1159724" h="3321050">
                  <a:moveTo>
                    <a:pt x="4024" y="3302000"/>
                  </a:moveTo>
                  <a:cubicBezTo>
                    <a:pt x="-11851" y="3287183"/>
                    <a:pt x="23989" y="3253889"/>
                    <a:pt x="29424" y="3232150"/>
                  </a:cubicBezTo>
                  <a:cubicBezTo>
                    <a:pt x="31541" y="3223683"/>
                    <a:pt x="33266" y="3215109"/>
                    <a:pt x="35774" y="3206750"/>
                  </a:cubicBezTo>
                  <a:cubicBezTo>
                    <a:pt x="39621" y="3193928"/>
                    <a:pt x="44241" y="3181350"/>
                    <a:pt x="48474" y="3168650"/>
                  </a:cubicBezTo>
                  <a:cubicBezTo>
                    <a:pt x="50591" y="3162300"/>
                    <a:pt x="53511" y="3156164"/>
                    <a:pt x="54824" y="3149600"/>
                  </a:cubicBezTo>
                  <a:cubicBezTo>
                    <a:pt x="56941" y="3139017"/>
                    <a:pt x="58747" y="3128367"/>
                    <a:pt x="61174" y="3117850"/>
                  </a:cubicBezTo>
                  <a:cubicBezTo>
                    <a:pt x="65099" y="3100843"/>
                    <a:pt x="73874" y="3067050"/>
                    <a:pt x="73874" y="3067050"/>
                  </a:cubicBezTo>
                  <a:cubicBezTo>
                    <a:pt x="75991" y="3028950"/>
                    <a:pt x="76606" y="2990737"/>
                    <a:pt x="80224" y="2952750"/>
                  </a:cubicBezTo>
                  <a:cubicBezTo>
                    <a:pt x="80859" y="2946087"/>
                    <a:pt x="86222" y="2940384"/>
                    <a:pt x="86574" y="2933700"/>
                  </a:cubicBezTo>
                  <a:cubicBezTo>
                    <a:pt x="90469" y="2859689"/>
                    <a:pt x="89559" y="2785487"/>
                    <a:pt x="92924" y="2711450"/>
                  </a:cubicBezTo>
                  <a:cubicBezTo>
                    <a:pt x="93921" y="2689524"/>
                    <a:pt x="100674" y="2640950"/>
                    <a:pt x="105624" y="2616200"/>
                  </a:cubicBezTo>
                  <a:cubicBezTo>
                    <a:pt x="107336" y="2607642"/>
                    <a:pt x="109857" y="2599267"/>
                    <a:pt x="111974" y="2590800"/>
                  </a:cubicBezTo>
                  <a:cubicBezTo>
                    <a:pt x="109857" y="2569633"/>
                    <a:pt x="105624" y="2548572"/>
                    <a:pt x="105624" y="2527300"/>
                  </a:cubicBezTo>
                  <a:cubicBezTo>
                    <a:pt x="105624" y="2490180"/>
                    <a:pt x="111569" y="2465826"/>
                    <a:pt x="118324" y="2432050"/>
                  </a:cubicBezTo>
                  <a:cubicBezTo>
                    <a:pt x="120441" y="2408767"/>
                    <a:pt x="121942" y="2385419"/>
                    <a:pt x="124674" y="2362200"/>
                  </a:cubicBezTo>
                  <a:cubicBezTo>
                    <a:pt x="126178" y="2349413"/>
                    <a:pt x="131024" y="2336975"/>
                    <a:pt x="131024" y="2324100"/>
                  </a:cubicBezTo>
                  <a:cubicBezTo>
                    <a:pt x="131024" y="2302828"/>
                    <a:pt x="126791" y="2281767"/>
                    <a:pt x="124674" y="2260600"/>
                  </a:cubicBezTo>
                  <a:cubicBezTo>
                    <a:pt x="135016" y="2074449"/>
                    <a:pt x="118322" y="2193932"/>
                    <a:pt x="137374" y="2127250"/>
                  </a:cubicBezTo>
                  <a:cubicBezTo>
                    <a:pt x="156568" y="2060072"/>
                    <a:pt x="126243" y="2154292"/>
                    <a:pt x="156424" y="2063750"/>
                  </a:cubicBezTo>
                  <a:lnTo>
                    <a:pt x="162774" y="2044700"/>
                  </a:lnTo>
                  <a:cubicBezTo>
                    <a:pt x="160657" y="2036233"/>
                    <a:pt x="156424" y="2028027"/>
                    <a:pt x="156424" y="2019300"/>
                  </a:cubicBezTo>
                  <a:cubicBezTo>
                    <a:pt x="156424" y="1989132"/>
                    <a:pt x="163262" y="1959711"/>
                    <a:pt x="169124" y="1930400"/>
                  </a:cubicBezTo>
                  <a:cubicBezTo>
                    <a:pt x="171241" y="1905000"/>
                    <a:pt x="174262" y="1879659"/>
                    <a:pt x="175474" y="1854200"/>
                  </a:cubicBezTo>
                  <a:cubicBezTo>
                    <a:pt x="185333" y="1647151"/>
                    <a:pt x="161386" y="1725014"/>
                    <a:pt x="188174" y="1644650"/>
                  </a:cubicBezTo>
                  <a:cubicBezTo>
                    <a:pt x="190291" y="1623483"/>
                    <a:pt x="194524" y="1602422"/>
                    <a:pt x="194524" y="1581150"/>
                  </a:cubicBezTo>
                  <a:cubicBezTo>
                    <a:pt x="194524" y="1553552"/>
                    <a:pt x="188174" y="1526198"/>
                    <a:pt x="188174" y="1498600"/>
                  </a:cubicBezTo>
                  <a:cubicBezTo>
                    <a:pt x="188174" y="1436447"/>
                    <a:pt x="188278" y="1441139"/>
                    <a:pt x="200874" y="1403350"/>
                  </a:cubicBezTo>
                  <a:cubicBezTo>
                    <a:pt x="202991" y="1354667"/>
                    <a:pt x="203487" y="1305886"/>
                    <a:pt x="207224" y="1257300"/>
                  </a:cubicBezTo>
                  <a:cubicBezTo>
                    <a:pt x="207737" y="1250626"/>
                    <a:pt x="212261" y="1244814"/>
                    <a:pt x="213574" y="1238250"/>
                  </a:cubicBezTo>
                  <a:cubicBezTo>
                    <a:pt x="236327" y="1124487"/>
                    <a:pt x="207449" y="1243699"/>
                    <a:pt x="226274" y="1168400"/>
                  </a:cubicBezTo>
                  <a:cubicBezTo>
                    <a:pt x="228391" y="1147233"/>
                    <a:pt x="229468" y="1125937"/>
                    <a:pt x="232624" y="1104900"/>
                  </a:cubicBezTo>
                  <a:cubicBezTo>
                    <a:pt x="235826" y="1083553"/>
                    <a:pt x="241775" y="1062692"/>
                    <a:pt x="245324" y="1041400"/>
                  </a:cubicBezTo>
                  <a:lnTo>
                    <a:pt x="251674" y="1003300"/>
                  </a:lnTo>
                  <a:cubicBezTo>
                    <a:pt x="239381" y="954130"/>
                    <a:pt x="245877" y="999430"/>
                    <a:pt x="251674" y="958850"/>
                  </a:cubicBezTo>
                  <a:cubicBezTo>
                    <a:pt x="265586" y="861466"/>
                    <a:pt x="248639" y="917154"/>
                    <a:pt x="264374" y="869950"/>
                  </a:cubicBezTo>
                  <a:cubicBezTo>
                    <a:pt x="266491" y="850900"/>
                    <a:pt x="267573" y="831706"/>
                    <a:pt x="270724" y="812800"/>
                  </a:cubicBezTo>
                  <a:cubicBezTo>
                    <a:pt x="271824" y="806198"/>
                    <a:pt x="277074" y="800443"/>
                    <a:pt x="277074" y="793750"/>
                  </a:cubicBezTo>
                  <a:cubicBezTo>
                    <a:pt x="277074" y="782957"/>
                    <a:pt x="272841" y="772583"/>
                    <a:pt x="270724" y="762000"/>
                  </a:cubicBezTo>
                  <a:cubicBezTo>
                    <a:pt x="272841" y="753533"/>
                    <a:pt x="273636" y="744622"/>
                    <a:pt x="277074" y="736600"/>
                  </a:cubicBezTo>
                  <a:cubicBezTo>
                    <a:pt x="280080" y="729585"/>
                    <a:pt x="287581" y="724860"/>
                    <a:pt x="289774" y="717550"/>
                  </a:cubicBezTo>
                  <a:cubicBezTo>
                    <a:pt x="294075" y="703214"/>
                    <a:pt x="293848" y="687893"/>
                    <a:pt x="296124" y="673100"/>
                  </a:cubicBezTo>
                  <a:cubicBezTo>
                    <a:pt x="298082" y="660375"/>
                    <a:pt x="300970" y="647787"/>
                    <a:pt x="302474" y="635000"/>
                  </a:cubicBezTo>
                  <a:cubicBezTo>
                    <a:pt x="305206" y="611781"/>
                    <a:pt x="306498" y="588413"/>
                    <a:pt x="308824" y="565150"/>
                  </a:cubicBezTo>
                  <a:cubicBezTo>
                    <a:pt x="312883" y="524563"/>
                    <a:pt x="315543" y="502425"/>
                    <a:pt x="321524" y="463550"/>
                  </a:cubicBezTo>
                  <a:cubicBezTo>
                    <a:pt x="327910" y="422041"/>
                    <a:pt x="324356" y="436004"/>
                    <a:pt x="334224" y="406400"/>
                  </a:cubicBezTo>
                  <a:cubicBezTo>
                    <a:pt x="336341" y="376767"/>
                    <a:pt x="337293" y="347027"/>
                    <a:pt x="340574" y="317500"/>
                  </a:cubicBezTo>
                  <a:cubicBezTo>
                    <a:pt x="340595" y="317315"/>
                    <a:pt x="350264" y="276060"/>
                    <a:pt x="353274" y="273050"/>
                  </a:cubicBezTo>
                  <a:cubicBezTo>
                    <a:pt x="358007" y="268317"/>
                    <a:pt x="366337" y="269693"/>
                    <a:pt x="372324" y="266700"/>
                  </a:cubicBezTo>
                  <a:cubicBezTo>
                    <a:pt x="421563" y="242081"/>
                    <a:pt x="362541" y="263611"/>
                    <a:pt x="410424" y="247650"/>
                  </a:cubicBezTo>
                  <a:cubicBezTo>
                    <a:pt x="414657" y="241300"/>
                    <a:pt x="417728" y="233996"/>
                    <a:pt x="423124" y="228600"/>
                  </a:cubicBezTo>
                  <a:cubicBezTo>
                    <a:pt x="428520" y="223204"/>
                    <a:pt x="437406" y="221859"/>
                    <a:pt x="442174" y="215900"/>
                  </a:cubicBezTo>
                  <a:cubicBezTo>
                    <a:pt x="446355" y="210673"/>
                    <a:pt x="445531" y="202837"/>
                    <a:pt x="448524" y="196850"/>
                  </a:cubicBezTo>
                  <a:cubicBezTo>
                    <a:pt x="451937" y="190024"/>
                    <a:pt x="458124" y="184774"/>
                    <a:pt x="461224" y="177800"/>
                  </a:cubicBezTo>
                  <a:cubicBezTo>
                    <a:pt x="466661" y="165567"/>
                    <a:pt x="460937" y="142947"/>
                    <a:pt x="473924" y="139700"/>
                  </a:cubicBezTo>
                  <a:lnTo>
                    <a:pt x="499324" y="133350"/>
                  </a:lnTo>
                  <a:cubicBezTo>
                    <a:pt x="505674" y="137583"/>
                    <a:pt x="511548" y="142637"/>
                    <a:pt x="518374" y="146050"/>
                  </a:cubicBezTo>
                  <a:cubicBezTo>
                    <a:pt x="524361" y="149043"/>
                    <a:pt x="531573" y="149149"/>
                    <a:pt x="537424" y="152400"/>
                  </a:cubicBezTo>
                  <a:cubicBezTo>
                    <a:pt x="550767" y="159813"/>
                    <a:pt x="575524" y="177800"/>
                    <a:pt x="575524" y="177800"/>
                  </a:cubicBezTo>
                  <a:cubicBezTo>
                    <a:pt x="580382" y="158369"/>
                    <a:pt x="579956" y="147968"/>
                    <a:pt x="594574" y="133350"/>
                  </a:cubicBezTo>
                  <a:cubicBezTo>
                    <a:pt x="599970" y="127954"/>
                    <a:pt x="607274" y="124883"/>
                    <a:pt x="613624" y="120650"/>
                  </a:cubicBezTo>
                  <a:cubicBezTo>
                    <a:pt x="615741" y="112183"/>
                    <a:pt x="616071" y="103056"/>
                    <a:pt x="619974" y="95250"/>
                  </a:cubicBezTo>
                  <a:cubicBezTo>
                    <a:pt x="632674" y="69850"/>
                    <a:pt x="641141" y="56092"/>
                    <a:pt x="664424" y="44450"/>
                  </a:cubicBezTo>
                  <a:cubicBezTo>
                    <a:pt x="670411" y="41457"/>
                    <a:pt x="676940" y="39552"/>
                    <a:pt x="683474" y="38100"/>
                  </a:cubicBezTo>
                  <a:cubicBezTo>
                    <a:pt x="696043" y="35307"/>
                    <a:pt x="708874" y="33867"/>
                    <a:pt x="721574" y="31750"/>
                  </a:cubicBezTo>
                  <a:cubicBezTo>
                    <a:pt x="725807" y="25400"/>
                    <a:pt x="727802" y="16745"/>
                    <a:pt x="734274" y="12700"/>
                  </a:cubicBezTo>
                  <a:cubicBezTo>
                    <a:pt x="745626" y="5605"/>
                    <a:pt x="772374" y="0"/>
                    <a:pt x="772374" y="0"/>
                  </a:cubicBezTo>
                  <a:cubicBezTo>
                    <a:pt x="774491" y="6350"/>
                    <a:pt x="775731" y="13063"/>
                    <a:pt x="778724" y="19050"/>
                  </a:cubicBezTo>
                  <a:cubicBezTo>
                    <a:pt x="782137" y="25876"/>
                    <a:pt x="789011" y="30860"/>
                    <a:pt x="791424" y="38100"/>
                  </a:cubicBezTo>
                  <a:cubicBezTo>
                    <a:pt x="795495" y="50314"/>
                    <a:pt x="794651" y="63709"/>
                    <a:pt x="797774" y="76200"/>
                  </a:cubicBezTo>
                  <a:cubicBezTo>
                    <a:pt x="801021" y="89187"/>
                    <a:pt x="810474" y="114300"/>
                    <a:pt x="810474" y="114300"/>
                  </a:cubicBezTo>
                  <a:cubicBezTo>
                    <a:pt x="812591" y="137583"/>
                    <a:pt x="813518" y="161006"/>
                    <a:pt x="816824" y="184150"/>
                  </a:cubicBezTo>
                  <a:cubicBezTo>
                    <a:pt x="817771" y="190776"/>
                    <a:pt x="821861" y="196636"/>
                    <a:pt x="823174" y="203200"/>
                  </a:cubicBezTo>
                  <a:cubicBezTo>
                    <a:pt x="827202" y="223342"/>
                    <a:pt x="830627" y="264762"/>
                    <a:pt x="835874" y="285750"/>
                  </a:cubicBezTo>
                  <a:cubicBezTo>
                    <a:pt x="839121" y="298737"/>
                    <a:pt x="844341" y="311150"/>
                    <a:pt x="848574" y="323850"/>
                  </a:cubicBezTo>
                  <a:cubicBezTo>
                    <a:pt x="850691" y="330200"/>
                    <a:pt x="853611" y="336336"/>
                    <a:pt x="854924" y="342900"/>
                  </a:cubicBezTo>
                  <a:cubicBezTo>
                    <a:pt x="857041" y="353483"/>
                    <a:pt x="859343" y="364031"/>
                    <a:pt x="861274" y="374650"/>
                  </a:cubicBezTo>
                  <a:cubicBezTo>
                    <a:pt x="863577" y="387318"/>
                    <a:pt x="865099" y="400125"/>
                    <a:pt x="867624" y="412750"/>
                  </a:cubicBezTo>
                  <a:cubicBezTo>
                    <a:pt x="869336" y="421308"/>
                    <a:pt x="872081" y="429631"/>
                    <a:pt x="873974" y="438150"/>
                  </a:cubicBezTo>
                  <a:cubicBezTo>
                    <a:pt x="876315" y="448686"/>
                    <a:pt x="877484" y="459487"/>
                    <a:pt x="880324" y="469900"/>
                  </a:cubicBezTo>
                  <a:cubicBezTo>
                    <a:pt x="901887" y="548966"/>
                    <a:pt x="886215" y="467143"/>
                    <a:pt x="899374" y="546100"/>
                  </a:cubicBezTo>
                  <a:cubicBezTo>
                    <a:pt x="901491" y="577850"/>
                    <a:pt x="901224" y="609849"/>
                    <a:pt x="905724" y="641350"/>
                  </a:cubicBezTo>
                  <a:cubicBezTo>
                    <a:pt x="907617" y="654602"/>
                    <a:pt x="915177" y="666463"/>
                    <a:pt x="918424" y="679450"/>
                  </a:cubicBezTo>
                  <a:cubicBezTo>
                    <a:pt x="926397" y="711344"/>
                    <a:pt x="922014" y="696571"/>
                    <a:pt x="931124" y="723900"/>
                  </a:cubicBezTo>
                  <a:cubicBezTo>
                    <a:pt x="938178" y="857918"/>
                    <a:pt x="924739" y="806344"/>
                    <a:pt x="950174" y="882650"/>
                  </a:cubicBezTo>
                  <a:lnTo>
                    <a:pt x="950174" y="882650"/>
                  </a:lnTo>
                  <a:cubicBezTo>
                    <a:pt x="952291" y="891117"/>
                    <a:pt x="954016" y="899691"/>
                    <a:pt x="956524" y="908050"/>
                  </a:cubicBezTo>
                  <a:cubicBezTo>
                    <a:pt x="960371" y="920872"/>
                    <a:pt x="969224" y="946150"/>
                    <a:pt x="969224" y="946150"/>
                  </a:cubicBezTo>
                  <a:cubicBezTo>
                    <a:pt x="971341" y="969433"/>
                    <a:pt x="971511" y="992976"/>
                    <a:pt x="975574" y="1016000"/>
                  </a:cubicBezTo>
                  <a:cubicBezTo>
                    <a:pt x="977900" y="1029183"/>
                    <a:pt x="984041" y="1041400"/>
                    <a:pt x="988274" y="1054100"/>
                  </a:cubicBezTo>
                  <a:lnTo>
                    <a:pt x="1020024" y="1149350"/>
                  </a:lnTo>
                  <a:lnTo>
                    <a:pt x="1039074" y="1206500"/>
                  </a:lnTo>
                  <a:lnTo>
                    <a:pt x="1045424" y="1225550"/>
                  </a:lnTo>
                  <a:lnTo>
                    <a:pt x="1051774" y="1244600"/>
                  </a:lnTo>
                  <a:cubicBezTo>
                    <a:pt x="1053446" y="1262987"/>
                    <a:pt x="1058680" y="1333794"/>
                    <a:pt x="1064474" y="1358900"/>
                  </a:cubicBezTo>
                  <a:cubicBezTo>
                    <a:pt x="1067484" y="1371944"/>
                    <a:pt x="1077174" y="1397000"/>
                    <a:pt x="1077174" y="1397000"/>
                  </a:cubicBezTo>
                  <a:cubicBezTo>
                    <a:pt x="1079291" y="1411817"/>
                    <a:pt x="1080159" y="1426866"/>
                    <a:pt x="1083524" y="1441450"/>
                  </a:cubicBezTo>
                  <a:cubicBezTo>
                    <a:pt x="1086534" y="1454494"/>
                    <a:pt x="1094023" y="1466345"/>
                    <a:pt x="1096224" y="1479550"/>
                  </a:cubicBezTo>
                  <a:cubicBezTo>
                    <a:pt x="1104775" y="1530855"/>
                    <a:pt x="1098503" y="1505436"/>
                    <a:pt x="1115274" y="1555750"/>
                  </a:cubicBezTo>
                  <a:cubicBezTo>
                    <a:pt x="1117391" y="1562100"/>
                    <a:pt x="1117911" y="1569231"/>
                    <a:pt x="1121624" y="1574800"/>
                  </a:cubicBezTo>
                  <a:lnTo>
                    <a:pt x="1134324" y="1593850"/>
                  </a:lnTo>
                  <a:cubicBezTo>
                    <a:pt x="1136441" y="1610783"/>
                    <a:pt x="1137621" y="1627860"/>
                    <a:pt x="1140674" y="1644650"/>
                  </a:cubicBezTo>
                  <a:cubicBezTo>
                    <a:pt x="1141871" y="1651236"/>
                    <a:pt x="1145572" y="1657166"/>
                    <a:pt x="1147024" y="1663700"/>
                  </a:cubicBezTo>
                  <a:cubicBezTo>
                    <a:pt x="1161925" y="1730754"/>
                    <a:pt x="1145429" y="1677966"/>
                    <a:pt x="1159724" y="1720850"/>
                  </a:cubicBezTo>
                  <a:cubicBezTo>
                    <a:pt x="1157607" y="1729317"/>
                    <a:pt x="1155772" y="1737859"/>
                    <a:pt x="1153374" y="1746250"/>
                  </a:cubicBezTo>
                  <a:cubicBezTo>
                    <a:pt x="1149242" y="1760711"/>
                    <a:pt x="1145456" y="1773218"/>
                    <a:pt x="1134324" y="1784350"/>
                  </a:cubicBezTo>
                  <a:cubicBezTo>
                    <a:pt x="1128928" y="1789746"/>
                    <a:pt x="1121624" y="1792817"/>
                    <a:pt x="1115274" y="1797050"/>
                  </a:cubicBezTo>
                  <a:cubicBezTo>
                    <a:pt x="1113157" y="1803400"/>
                    <a:pt x="1112637" y="1810531"/>
                    <a:pt x="1108924" y="1816100"/>
                  </a:cubicBezTo>
                  <a:cubicBezTo>
                    <a:pt x="1087008" y="1848974"/>
                    <a:pt x="1081382" y="1822527"/>
                    <a:pt x="1064474" y="1873250"/>
                  </a:cubicBezTo>
                  <a:cubicBezTo>
                    <a:pt x="1055244" y="1900939"/>
                    <a:pt x="1055845" y="1910274"/>
                    <a:pt x="1039074" y="1930400"/>
                  </a:cubicBezTo>
                  <a:cubicBezTo>
                    <a:pt x="1021519" y="1951466"/>
                    <a:pt x="1019148" y="1944851"/>
                    <a:pt x="1007324" y="1968500"/>
                  </a:cubicBezTo>
                  <a:cubicBezTo>
                    <a:pt x="1004331" y="1974487"/>
                    <a:pt x="1004687" y="1981981"/>
                    <a:pt x="1000974" y="1987550"/>
                  </a:cubicBezTo>
                  <a:cubicBezTo>
                    <a:pt x="995993" y="1995022"/>
                    <a:pt x="987673" y="1999701"/>
                    <a:pt x="981924" y="2006600"/>
                  </a:cubicBezTo>
                  <a:cubicBezTo>
                    <a:pt x="977038" y="2012463"/>
                    <a:pt x="974110" y="2019787"/>
                    <a:pt x="969224" y="2025650"/>
                  </a:cubicBezTo>
                  <a:cubicBezTo>
                    <a:pt x="950961" y="2047566"/>
                    <a:pt x="935473" y="2050702"/>
                    <a:pt x="924774" y="2082800"/>
                  </a:cubicBezTo>
                  <a:cubicBezTo>
                    <a:pt x="908813" y="2130683"/>
                    <a:pt x="930343" y="2071661"/>
                    <a:pt x="905724" y="2120900"/>
                  </a:cubicBezTo>
                  <a:cubicBezTo>
                    <a:pt x="902731" y="2126887"/>
                    <a:pt x="902625" y="2134099"/>
                    <a:pt x="899374" y="2139950"/>
                  </a:cubicBezTo>
                  <a:cubicBezTo>
                    <a:pt x="891961" y="2153293"/>
                    <a:pt x="878801" y="2163570"/>
                    <a:pt x="873974" y="2178050"/>
                  </a:cubicBezTo>
                  <a:cubicBezTo>
                    <a:pt x="871857" y="2184400"/>
                    <a:pt x="870875" y="2191249"/>
                    <a:pt x="867624" y="2197100"/>
                  </a:cubicBezTo>
                  <a:cubicBezTo>
                    <a:pt x="860211" y="2210443"/>
                    <a:pt x="847051" y="2220720"/>
                    <a:pt x="842224" y="2235200"/>
                  </a:cubicBezTo>
                  <a:cubicBezTo>
                    <a:pt x="840107" y="2241550"/>
                    <a:pt x="839125" y="2248399"/>
                    <a:pt x="835874" y="2254250"/>
                  </a:cubicBezTo>
                  <a:cubicBezTo>
                    <a:pt x="828461" y="2267593"/>
                    <a:pt x="815301" y="2277870"/>
                    <a:pt x="810474" y="2292350"/>
                  </a:cubicBezTo>
                  <a:cubicBezTo>
                    <a:pt x="794513" y="2340233"/>
                    <a:pt x="816043" y="2281211"/>
                    <a:pt x="791424" y="2330450"/>
                  </a:cubicBezTo>
                  <a:cubicBezTo>
                    <a:pt x="788431" y="2336437"/>
                    <a:pt x="788325" y="2343649"/>
                    <a:pt x="785074" y="2349500"/>
                  </a:cubicBezTo>
                  <a:cubicBezTo>
                    <a:pt x="777661" y="2362843"/>
                    <a:pt x="768141" y="2374900"/>
                    <a:pt x="759674" y="2387600"/>
                  </a:cubicBezTo>
                  <a:lnTo>
                    <a:pt x="746974" y="2406650"/>
                  </a:lnTo>
                  <a:cubicBezTo>
                    <a:pt x="742741" y="2413000"/>
                    <a:pt x="739670" y="2420304"/>
                    <a:pt x="734274" y="2425700"/>
                  </a:cubicBezTo>
                  <a:cubicBezTo>
                    <a:pt x="727924" y="2432050"/>
                    <a:pt x="720737" y="2437661"/>
                    <a:pt x="715224" y="2444750"/>
                  </a:cubicBezTo>
                  <a:cubicBezTo>
                    <a:pt x="705853" y="2456798"/>
                    <a:pt x="698291" y="2470150"/>
                    <a:pt x="689824" y="2482850"/>
                  </a:cubicBezTo>
                  <a:lnTo>
                    <a:pt x="664424" y="2520950"/>
                  </a:lnTo>
                  <a:lnTo>
                    <a:pt x="651724" y="2540000"/>
                  </a:lnTo>
                  <a:cubicBezTo>
                    <a:pt x="647491" y="2546350"/>
                    <a:pt x="644420" y="2553654"/>
                    <a:pt x="639024" y="2559050"/>
                  </a:cubicBezTo>
                  <a:cubicBezTo>
                    <a:pt x="632674" y="2565400"/>
                    <a:pt x="625723" y="2571201"/>
                    <a:pt x="619974" y="2578100"/>
                  </a:cubicBezTo>
                  <a:cubicBezTo>
                    <a:pt x="593516" y="2609850"/>
                    <a:pt x="623149" y="2586567"/>
                    <a:pt x="588224" y="2609850"/>
                  </a:cubicBezTo>
                  <a:cubicBezTo>
                    <a:pt x="583991" y="2616200"/>
                    <a:pt x="580410" y="2623037"/>
                    <a:pt x="575524" y="2628900"/>
                  </a:cubicBezTo>
                  <a:cubicBezTo>
                    <a:pt x="569775" y="2635799"/>
                    <a:pt x="561455" y="2640478"/>
                    <a:pt x="556474" y="2647950"/>
                  </a:cubicBezTo>
                  <a:cubicBezTo>
                    <a:pt x="552761" y="2653519"/>
                    <a:pt x="553375" y="2661149"/>
                    <a:pt x="550124" y="2667000"/>
                  </a:cubicBezTo>
                  <a:cubicBezTo>
                    <a:pt x="542711" y="2680343"/>
                    <a:pt x="529551" y="2690620"/>
                    <a:pt x="524724" y="2705100"/>
                  </a:cubicBezTo>
                  <a:cubicBezTo>
                    <a:pt x="520491" y="2717800"/>
                    <a:pt x="519450" y="2732061"/>
                    <a:pt x="512024" y="2743200"/>
                  </a:cubicBezTo>
                  <a:cubicBezTo>
                    <a:pt x="475628" y="2797795"/>
                    <a:pt x="519264" y="2728720"/>
                    <a:pt x="492974" y="2781300"/>
                  </a:cubicBezTo>
                  <a:cubicBezTo>
                    <a:pt x="489561" y="2788126"/>
                    <a:pt x="483374" y="2793376"/>
                    <a:pt x="480274" y="2800350"/>
                  </a:cubicBezTo>
                  <a:cubicBezTo>
                    <a:pt x="474837" y="2812583"/>
                    <a:pt x="471807" y="2825750"/>
                    <a:pt x="467574" y="2838450"/>
                  </a:cubicBezTo>
                  <a:lnTo>
                    <a:pt x="454874" y="2876550"/>
                  </a:lnTo>
                  <a:cubicBezTo>
                    <a:pt x="452757" y="2882900"/>
                    <a:pt x="452237" y="2890031"/>
                    <a:pt x="448524" y="2895600"/>
                  </a:cubicBezTo>
                  <a:cubicBezTo>
                    <a:pt x="412128" y="2950195"/>
                    <a:pt x="455764" y="2881120"/>
                    <a:pt x="429474" y="2933700"/>
                  </a:cubicBezTo>
                  <a:cubicBezTo>
                    <a:pt x="426061" y="2940526"/>
                    <a:pt x="420187" y="2945924"/>
                    <a:pt x="416774" y="2952750"/>
                  </a:cubicBezTo>
                  <a:cubicBezTo>
                    <a:pt x="413781" y="2958737"/>
                    <a:pt x="413675" y="2965949"/>
                    <a:pt x="410424" y="2971800"/>
                  </a:cubicBezTo>
                  <a:cubicBezTo>
                    <a:pt x="388635" y="3011021"/>
                    <a:pt x="393802" y="3004048"/>
                    <a:pt x="365974" y="3022600"/>
                  </a:cubicBezTo>
                  <a:cubicBezTo>
                    <a:pt x="363857" y="3028950"/>
                    <a:pt x="362875" y="3035799"/>
                    <a:pt x="359624" y="3041650"/>
                  </a:cubicBezTo>
                  <a:cubicBezTo>
                    <a:pt x="352211" y="3054993"/>
                    <a:pt x="339051" y="3065270"/>
                    <a:pt x="334224" y="3079750"/>
                  </a:cubicBezTo>
                  <a:cubicBezTo>
                    <a:pt x="318263" y="3127633"/>
                    <a:pt x="339793" y="3068611"/>
                    <a:pt x="315174" y="3117850"/>
                  </a:cubicBezTo>
                  <a:cubicBezTo>
                    <a:pt x="312181" y="3123837"/>
                    <a:pt x="312075" y="3131049"/>
                    <a:pt x="308824" y="3136900"/>
                  </a:cubicBezTo>
                  <a:cubicBezTo>
                    <a:pt x="301411" y="3150243"/>
                    <a:pt x="291891" y="3162300"/>
                    <a:pt x="283424" y="3175000"/>
                  </a:cubicBezTo>
                  <a:cubicBezTo>
                    <a:pt x="279191" y="3181350"/>
                    <a:pt x="273137" y="3186810"/>
                    <a:pt x="270724" y="3194050"/>
                  </a:cubicBezTo>
                  <a:cubicBezTo>
                    <a:pt x="259547" y="3227580"/>
                    <a:pt x="268087" y="3207531"/>
                    <a:pt x="238974" y="3251200"/>
                  </a:cubicBezTo>
                  <a:cubicBezTo>
                    <a:pt x="234741" y="3257550"/>
                    <a:pt x="233514" y="3267837"/>
                    <a:pt x="226274" y="3270250"/>
                  </a:cubicBezTo>
                  <a:cubicBezTo>
                    <a:pt x="199984" y="3279013"/>
                    <a:pt x="212793" y="3272887"/>
                    <a:pt x="188174" y="3289300"/>
                  </a:cubicBezTo>
                  <a:cubicBezTo>
                    <a:pt x="183941" y="3295650"/>
                    <a:pt x="181433" y="3303582"/>
                    <a:pt x="175474" y="3308350"/>
                  </a:cubicBezTo>
                  <a:cubicBezTo>
                    <a:pt x="168965" y="3313557"/>
                    <a:pt x="126255" y="3320734"/>
                    <a:pt x="124674" y="3321050"/>
                  </a:cubicBezTo>
                  <a:cubicBezTo>
                    <a:pt x="-193" y="3314113"/>
                    <a:pt x="19899" y="3316817"/>
                    <a:pt x="4024" y="3302000"/>
                  </a:cubicBezTo>
                  <a:close/>
                </a:path>
              </a:pathLst>
            </a:custGeom>
            <a:solidFill>
              <a:schemeClr val="bg2"/>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o-RO" sz="1350"/>
            </a:p>
          </p:txBody>
        </p:sp>
        <p:graphicFrame>
          <p:nvGraphicFramePr>
            <p:cNvPr id="2" name="Object 1"/>
            <p:cNvGraphicFramePr>
              <a:graphicFrameLocks noChangeAspect="1"/>
            </p:cNvGraphicFramePr>
            <p:nvPr>
              <p:extLst>
                <p:ext uri="{D42A27DB-BD31-4B8C-83A1-F6EECF244321}">
                  <p14:modId xmlns:p14="http://schemas.microsoft.com/office/powerpoint/2010/main" val="2418078987"/>
                </p:ext>
              </p:extLst>
            </p:nvPr>
          </p:nvGraphicFramePr>
          <p:xfrm>
            <a:off x="1098550" y="341313"/>
            <a:ext cx="8743950" cy="6138862"/>
          </p:xfrm>
          <a:graphic>
            <a:graphicData uri="http://schemas.openxmlformats.org/presentationml/2006/ole">
              <mc:AlternateContent xmlns:mc="http://schemas.openxmlformats.org/markup-compatibility/2006">
                <mc:Choice xmlns:v="urn:schemas-microsoft-com:vml" Requires="v">
                  <p:oleObj spid="_x0000_s1026" name="Prism Project" r:id="rId4" imgW="3384000" imgH="2376000" progId="Prism5.Document">
                    <p:embed/>
                  </p:oleObj>
                </mc:Choice>
                <mc:Fallback>
                  <p:oleObj name="Prism Project" r:id="rId4" imgW="3384000" imgH="2376000" progId="Prism5.Document">
                    <p:embed/>
                    <p:pic>
                      <p:nvPicPr>
                        <p:cNvPr id="0" name=""/>
                        <p:cNvPicPr/>
                        <p:nvPr/>
                      </p:nvPicPr>
                      <p:blipFill>
                        <a:blip r:embed="rId5"/>
                        <a:stretch>
                          <a:fillRect/>
                        </a:stretch>
                      </p:blipFill>
                      <p:spPr>
                        <a:xfrm>
                          <a:off x="1098550" y="341313"/>
                          <a:ext cx="8743950" cy="6138862"/>
                        </a:xfrm>
                        <a:prstGeom prst="rect">
                          <a:avLst/>
                        </a:prstGeom>
                        <a:ln w="28575">
                          <a:noFill/>
                        </a:ln>
                      </p:spPr>
                    </p:pic>
                  </p:oleObj>
                </mc:Fallback>
              </mc:AlternateContent>
            </a:graphicData>
          </a:graphic>
        </p:graphicFrame>
        <p:grpSp>
          <p:nvGrpSpPr>
            <p:cNvPr id="7" name="Group 6"/>
            <p:cNvGrpSpPr/>
            <p:nvPr/>
          </p:nvGrpSpPr>
          <p:grpSpPr>
            <a:xfrm>
              <a:off x="4672997" y="1743543"/>
              <a:ext cx="824809" cy="3545699"/>
              <a:chOff x="2722260" y="1723144"/>
              <a:chExt cx="824809" cy="3545699"/>
            </a:xfrm>
          </p:grpSpPr>
          <p:cxnSp>
            <p:nvCxnSpPr>
              <p:cNvPr id="8" name="Straight Arrow Connector 7"/>
              <p:cNvCxnSpPr/>
              <p:nvPr/>
            </p:nvCxnSpPr>
            <p:spPr>
              <a:xfrm>
                <a:off x="3414980" y="1828800"/>
                <a:ext cx="0" cy="3369151"/>
              </a:xfrm>
              <a:prstGeom prst="straightConnector1">
                <a:avLst/>
              </a:prstGeom>
              <a:ln w="12700">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grpSp>
            <p:nvGrpSpPr>
              <p:cNvPr id="9" name="Group 8"/>
              <p:cNvGrpSpPr/>
              <p:nvPr/>
            </p:nvGrpSpPr>
            <p:grpSpPr>
              <a:xfrm>
                <a:off x="2722260" y="1723144"/>
                <a:ext cx="824809" cy="3545699"/>
                <a:chOff x="2722260" y="1723144"/>
                <a:chExt cx="824809" cy="3545699"/>
              </a:xfrm>
            </p:grpSpPr>
            <p:sp>
              <p:nvSpPr>
                <p:cNvPr id="10" name="Rectangle 9"/>
                <p:cNvSpPr/>
                <p:nvPr/>
              </p:nvSpPr>
              <p:spPr>
                <a:xfrm>
                  <a:off x="3016788" y="4759642"/>
                  <a:ext cx="530281" cy="509201"/>
                </a:xfrm>
                <a:prstGeom prst="rect">
                  <a:avLst/>
                </a:prstGeom>
              </p:spPr>
              <p:txBody>
                <a:bodyPr wrap="none">
                  <a:spAutoFit/>
                </a:bodyPr>
                <a:lstStyle/>
                <a:p>
                  <a:r>
                    <a:rPr lang="en-US" sz="1650" dirty="0"/>
                    <a:t>F</a:t>
                  </a:r>
                  <a:r>
                    <a:rPr lang="en-US" sz="1650" baseline="-25000" dirty="0"/>
                    <a:t>0</a:t>
                  </a:r>
                  <a:endParaRPr lang="ro-RO" sz="1650" dirty="0"/>
                </a:p>
              </p:txBody>
            </p:sp>
            <p:sp>
              <p:nvSpPr>
                <p:cNvPr id="11" name="Rectangle 10"/>
                <p:cNvSpPr/>
                <p:nvPr/>
              </p:nvSpPr>
              <p:spPr>
                <a:xfrm>
                  <a:off x="2722260" y="1723144"/>
                  <a:ext cx="774638" cy="509201"/>
                </a:xfrm>
                <a:prstGeom prst="rect">
                  <a:avLst/>
                </a:prstGeom>
              </p:spPr>
              <p:txBody>
                <a:bodyPr wrap="none">
                  <a:spAutoFit/>
                </a:bodyPr>
                <a:lstStyle/>
                <a:p>
                  <a:r>
                    <a:rPr lang="en-US" sz="1650" dirty="0" err="1"/>
                    <a:t>F</a:t>
                  </a:r>
                  <a:r>
                    <a:rPr lang="en-US" sz="1650" baseline="-25000" dirty="0" err="1"/>
                    <a:t>max</a:t>
                  </a:r>
                  <a:endParaRPr lang="ro-RO" sz="1650" dirty="0"/>
                </a:p>
              </p:txBody>
            </p:sp>
            <p:sp>
              <p:nvSpPr>
                <p:cNvPr id="12" name="Rectangle 11"/>
                <p:cNvSpPr/>
                <p:nvPr/>
              </p:nvSpPr>
              <p:spPr>
                <a:xfrm rot="16200000">
                  <a:off x="2621935" y="3236237"/>
                  <a:ext cx="1007086" cy="493284"/>
                </a:xfrm>
                <a:prstGeom prst="rect">
                  <a:avLst/>
                </a:prstGeom>
              </p:spPr>
              <p:txBody>
                <a:bodyPr wrap="none">
                  <a:spAutoFit/>
                </a:bodyPr>
                <a:lstStyle/>
                <a:p>
                  <a:r>
                    <a:rPr lang="en-US" sz="1650" dirty="0"/>
                    <a:t>ΔF/F</a:t>
                  </a:r>
                  <a:r>
                    <a:rPr lang="en-US" sz="1650" baseline="-25000" dirty="0"/>
                    <a:t>0</a:t>
                  </a:r>
                  <a:endParaRPr lang="ro-RO" sz="1650" dirty="0"/>
                </a:p>
              </p:txBody>
            </p:sp>
          </p:grpSp>
        </p:grpSp>
        <p:grpSp>
          <p:nvGrpSpPr>
            <p:cNvPr id="13" name="Group 12"/>
            <p:cNvGrpSpPr/>
            <p:nvPr/>
          </p:nvGrpSpPr>
          <p:grpSpPr>
            <a:xfrm>
              <a:off x="5365717" y="891782"/>
              <a:ext cx="3350747" cy="4708918"/>
              <a:chOff x="5365717" y="891782"/>
              <a:chExt cx="3350747" cy="4708918"/>
            </a:xfrm>
          </p:grpSpPr>
          <p:cxnSp>
            <p:nvCxnSpPr>
              <p:cNvPr id="14" name="Straight Arrow Connector 13"/>
              <p:cNvCxnSpPr/>
              <p:nvPr/>
            </p:nvCxnSpPr>
            <p:spPr>
              <a:xfrm>
                <a:off x="8716463" y="1257300"/>
                <a:ext cx="0" cy="4343400"/>
              </a:xfrm>
              <a:prstGeom prst="straightConnector1">
                <a:avLst/>
              </a:prstGeom>
              <a:ln w="12700">
                <a:solidFill>
                  <a:schemeClr val="tx1"/>
                </a:solidFill>
                <a:prstDash val="dash"/>
                <a:headEnd type="none" w="med" len="med"/>
                <a:tailEnd type="none" w="med" len="med"/>
              </a:ln>
            </p:spPr>
            <p:style>
              <a:lnRef idx="1">
                <a:schemeClr val="accent1"/>
              </a:lnRef>
              <a:fillRef idx="0">
                <a:schemeClr val="accent1"/>
              </a:fillRef>
              <a:effectRef idx="0">
                <a:schemeClr val="accent1"/>
              </a:effectRef>
              <a:fontRef idx="minor">
                <a:schemeClr val="tx1"/>
              </a:fontRef>
            </p:style>
          </p:cxnSp>
          <p:grpSp>
            <p:nvGrpSpPr>
              <p:cNvPr id="15" name="Group 14"/>
              <p:cNvGrpSpPr/>
              <p:nvPr/>
            </p:nvGrpSpPr>
            <p:grpSpPr>
              <a:xfrm>
                <a:off x="5365717" y="891782"/>
                <a:ext cx="3350747" cy="4708918"/>
                <a:chOff x="5365717" y="891782"/>
                <a:chExt cx="3350747" cy="4708918"/>
              </a:xfrm>
            </p:grpSpPr>
            <p:cxnSp>
              <p:nvCxnSpPr>
                <p:cNvPr id="16" name="Straight Arrow Connector 15"/>
                <p:cNvCxnSpPr/>
                <p:nvPr/>
              </p:nvCxnSpPr>
              <p:spPr>
                <a:xfrm>
                  <a:off x="5365717" y="1257300"/>
                  <a:ext cx="0" cy="4343400"/>
                </a:xfrm>
                <a:prstGeom prst="straightConnector1">
                  <a:avLst/>
                </a:prstGeom>
                <a:ln w="12700">
                  <a:solidFill>
                    <a:schemeClr val="tx1"/>
                  </a:solidFill>
                  <a:prstDash val="dash"/>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flipH="1">
                  <a:off x="5365717" y="1257300"/>
                  <a:ext cx="3350747" cy="0"/>
                </a:xfrm>
                <a:prstGeom prst="straightConnector1">
                  <a:avLst/>
                </a:prstGeom>
                <a:ln w="12700">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6107342" y="891782"/>
                  <a:ext cx="1881786" cy="509201"/>
                </a:xfrm>
                <a:prstGeom prst="rect">
                  <a:avLst/>
                </a:prstGeom>
                <a:noFill/>
              </p:spPr>
              <p:txBody>
                <a:bodyPr wrap="none" rtlCol="0">
                  <a:spAutoFit/>
                </a:bodyPr>
                <a:lstStyle/>
                <a:p>
                  <a:r>
                    <a:rPr lang="en-US" sz="1650" dirty="0">
                      <a:latin typeface="Times New Roman" pitchFamily="18" charset="0"/>
                      <a:cs typeface="Times New Roman" pitchFamily="18" charset="0"/>
                    </a:rPr>
                    <a:t>Total interval</a:t>
                  </a:r>
                  <a:endParaRPr lang="ro-RO" sz="1650" dirty="0">
                    <a:latin typeface="Times New Roman" pitchFamily="18" charset="0"/>
                    <a:cs typeface="Times New Roman" pitchFamily="18" charset="0"/>
                  </a:endParaRPr>
                </a:p>
              </p:txBody>
            </p:sp>
          </p:grpSp>
        </p:grpSp>
        <p:grpSp>
          <p:nvGrpSpPr>
            <p:cNvPr id="25" name="Group 24"/>
            <p:cNvGrpSpPr/>
            <p:nvPr/>
          </p:nvGrpSpPr>
          <p:grpSpPr>
            <a:xfrm>
              <a:off x="5365717" y="1828800"/>
              <a:ext cx="1923604" cy="3437036"/>
              <a:chOff x="5365717" y="1828800"/>
              <a:chExt cx="1923604" cy="3437036"/>
            </a:xfrm>
          </p:grpSpPr>
          <p:cxnSp>
            <p:nvCxnSpPr>
              <p:cNvPr id="20" name="Straight Arrow Connector 19"/>
              <p:cNvCxnSpPr/>
              <p:nvPr/>
            </p:nvCxnSpPr>
            <p:spPr>
              <a:xfrm flipH="1">
                <a:off x="5365717" y="5260176"/>
                <a:ext cx="1196197" cy="0"/>
              </a:xfrm>
              <a:prstGeom prst="straightConnector1">
                <a:avLst/>
              </a:prstGeom>
              <a:ln w="12700">
                <a:solidFill>
                  <a:schemeClr val="tx1"/>
                </a:solidFill>
                <a:prstDash val="dash"/>
                <a:headEnd type="none" w="med" len="med"/>
                <a:tailEnd type="none" w="med" len="med"/>
              </a:ln>
            </p:spPr>
            <p:style>
              <a:lnRef idx="1">
                <a:schemeClr val="accent1"/>
              </a:lnRef>
              <a:fillRef idx="0">
                <a:schemeClr val="accent1"/>
              </a:fillRef>
              <a:effectRef idx="0">
                <a:schemeClr val="accent1"/>
              </a:effectRef>
              <a:fontRef idx="minor">
                <a:schemeClr val="tx1"/>
              </a:fontRef>
            </p:style>
          </p:cxnSp>
          <p:grpSp>
            <p:nvGrpSpPr>
              <p:cNvPr id="24" name="Group 23"/>
              <p:cNvGrpSpPr/>
              <p:nvPr/>
            </p:nvGrpSpPr>
            <p:grpSpPr>
              <a:xfrm>
                <a:off x="6239160" y="1828800"/>
                <a:ext cx="1050161" cy="3437036"/>
                <a:chOff x="6239160" y="1828800"/>
                <a:chExt cx="1050161" cy="3437036"/>
              </a:xfrm>
            </p:grpSpPr>
            <p:cxnSp>
              <p:nvCxnSpPr>
                <p:cNvPr id="19" name="Straight Arrow Connector 18"/>
                <p:cNvCxnSpPr/>
                <p:nvPr/>
              </p:nvCxnSpPr>
              <p:spPr>
                <a:xfrm>
                  <a:off x="6239160" y="1828800"/>
                  <a:ext cx="391123" cy="1740507"/>
                </a:xfrm>
                <a:prstGeom prst="straightConnector1">
                  <a:avLst/>
                </a:prstGeom>
                <a:ln w="15875">
                  <a:solidFill>
                    <a:schemeClr val="tx1"/>
                  </a:solidFill>
                  <a:headEnd type="triangle" w="lg" len="med"/>
                  <a:tailEnd type="triangle" w="lg" len="med"/>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p:nvPr/>
              </p:nvCxnSpPr>
              <p:spPr>
                <a:xfrm>
                  <a:off x="6561913" y="3569307"/>
                  <a:ext cx="0" cy="1696529"/>
                </a:xfrm>
                <a:prstGeom prst="straightConnector1">
                  <a:avLst/>
                </a:prstGeom>
                <a:ln w="12700">
                  <a:solidFill>
                    <a:schemeClr val="tx1"/>
                  </a:solidFill>
                  <a:prstDash val="dash"/>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2" name="TextBox 21"/>
                <p:cNvSpPr txBox="1"/>
                <p:nvPr/>
              </p:nvSpPr>
              <p:spPr>
                <a:xfrm rot="4639531">
                  <a:off x="6188423" y="2452409"/>
                  <a:ext cx="981155" cy="493284"/>
                </a:xfrm>
                <a:prstGeom prst="rect">
                  <a:avLst/>
                </a:prstGeom>
                <a:noFill/>
              </p:spPr>
              <p:txBody>
                <a:bodyPr wrap="none" rtlCol="0">
                  <a:spAutoFit/>
                </a:bodyPr>
                <a:lstStyle/>
                <a:p>
                  <a:r>
                    <a:rPr lang="en-US" sz="1650" dirty="0"/>
                    <a:t>Slope</a:t>
                  </a:r>
                  <a:endParaRPr lang="ro-RO" sz="1650" dirty="0"/>
                </a:p>
              </p:txBody>
            </p:sp>
            <p:sp>
              <p:nvSpPr>
                <p:cNvPr id="23" name="TextBox 22"/>
                <p:cNvSpPr txBox="1"/>
                <p:nvPr/>
              </p:nvSpPr>
              <p:spPr>
                <a:xfrm>
                  <a:off x="6586002" y="3244335"/>
                  <a:ext cx="703319" cy="509201"/>
                </a:xfrm>
                <a:prstGeom prst="rect">
                  <a:avLst/>
                </a:prstGeom>
                <a:noFill/>
              </p:spPr>
              <p:txBody>
                <a:bodyPr wrap="square" rtlCol="0">
                  <a:spAutoFit/>
                </a:bodyPr>
                <a:lstStyle/>
                <a:p>
                  <a:r>
                    <a:rPr lang="en-US" sz="1650" dirty="0"/>
                    <a:t>T</a:t>
                  </a:r>
                  <a:r>
                    <a:rPr lang="en-US" sz="1650" baseline="-25000" dirty="0"/>
                    <a:t>50</a:t>
                  </a:r>
                  <a:endParaRPr lang="ro-RO" sz="1650" dirty="0"/>
                </a:p>
              </p:txBody>
            </p:sp>
          </p:grpSp>
        </p:grpSp>
        <p:sp>
          <p:nvSpPr>
            <p:cNvPr id="31" name="TextBox 30"/>
            <p:cNvSpPr txBox="1"/>
            <p:nvPr/>
          </p:nvSpPr>
          <p:spPr>
            <a:xfrm>
              <a:off x="5472752" y="4828623"/>
              <a:ext cx="1089161" cy="441307"/>
            </a:xfrm>
            <a:prstGeom prst="rect">
              <a:avLst/>
            </a:prstGeom>
            <a:noFill/>
          </p:spPr>
          <p:txBody>
            <a:bodyPr wrap="square" rtlCol="0">
              <a:spAutoFit/>
            </a:bodyPr>
            <a:lstStyle/>
            <a:p>
              <a:pPr algn="ctr"/>
              <a:r>
                <a:rPr lang="en-US" sz="1350" dirty="0"/>
                <a:t>AUC</a:t>
              </a:r>
              <a:endParaRPr lang="ro-RO" sz="1350" dirty="0"/>
            </a:p>
          </p:txBody>
        </p:sp>
      </p:grpSp>
      <p:sp>
        <p:nvSpPr>
          <p:cNvPr id="6" name="TextBox 5">
            <a:extLst>
              <a:ext uri="{FF2B5EF4-FFF2-40B4-BE49-F238E27FC236}">
                <a16:creationId xmlns:a16="http://schemas.microsoft.com/office/drawing/2014/main" id="{BFA9D7EC-537B-E627-BDA2-26CEF10D1AF2}"/>
              </a:ext>
            </a:extLst>
          </p:cNvPr>
          <p:cNvSpPr txBox="1"/>
          <p:nvPr/>
        </p:nvSpPr>
        <p:spPr>
          <a:xfrm>
            <a:off x="897654" y="4844101"/>
            <a:ext cx="6888923" cy="1774204"/>
          </a:xfrm>
          <a:prstGeom prst="rect">
            <a:avLst/>
          </a:prstGeom>
          <a:noFill/>
        </p:spPr>
        <p:txBody>
          <a:bodyPr wrap="square">
            <a:spAutoFit/>
          </a:bodyPr>
          <a:lstStyle/>
          <a:p>
            <a:pPr marL="0" marR="0" indent="0" algn="just">
              <a:lnSpc>
                <a:spcPct val="115000"/>
              </a:lnSpc>
              <a:spcBef>
                <a:spcPts val="0"/>
              </a:spcBef>
              <a:spcAft>
                <a:spcPts val="800"/>
              </a:spcAft>
            </a:pPr>
            <a:r>
              <a:rPr lang="en-US" sz="1200" b="1" dirty="0">
                <a:effectLst/>
                <a:latin typeface="Times New Roman" panose="02020603050405020304" pitchFamily="18" charset="0"/>
                <a:ea typeface="Times New Roman" panose="02020603050405020304" pitchFamily="18" charset="0"/>
              </a:rPr>
              <a:t>Supplemental </a:t>
            </a:r>
            <a:r>
              <a:rPr lang="en-US" sz="1200" b="1">
                <a:effectLst/>
                <a:latin typeface="Times New Roman" panose="02020603050405020304" pitchFamily="18" charset="0"/>
                <a:ea typeface="Times New Roman" panose="02020603050405020304" pitchFamily="18" charset="0"/>
              </a:rPr>
              <a:t>Figure S5</a:t>
            </a:r>
            <a:r>
              <a:rPr lang="en-US" sz="1200" b="1" dirty="0">
                <a:effectLst/>
                <a:latin typeface="Times New Roman" panose="02020603050405020304" pitchFamily="18" charset="0"/>
                <a:ea typeface="Times New Roman" panose="02020603050405020304" pitchFamily="18" charset="0"/>
              </a:rPr>
              <a:t>.</a:t>
            </a:r>
            <a:r>
              <a:rPr lang="en-US" sz="1200" dirty="0">
                <a:effectLst/>
                <a:latin typeface="Times New Roman" panose="02020603050405020304" pitchFamily="18" charset="0"/>
                <a:ea typeface="Times New Roman" panose="02020603050405020304" pitchFamily="18" charset="0"/>
              </a:rPr>
              <a:t> Schematic drawing representing parameters that have been determined for </a:t>
            </a:r>
            <a:r>
              <a:rPr lang="en-US" sz="1200" dirty="0" err="1">
                <a:effectLst/>
                <a:latin typeface="Times New Roman" panose="02020603050405020304" pitchFamily="18" charset="0"/>
                <a:ea typeface="Times New Roman" panose="02020603050405020304" pitchFamily="18" charset="0"/>
              </a:rPr>
              <a:t>ratiometric</a:t>
            </a:r>
            <a:r>
              <a:rPr lang="en-US" sz="1200" dirty="0">
                <a:effectLst/>
                <a:latin typeface="Times New Roman" panose="02020603050405020304" pitchFamily="18" charset="0"/>
                <a:ea typeface="Times New Roman" panose="02020603050405020304" pitchFamily="18" charset="0"/>
              </a:rPr>
              <a:t> intracellular Ca</a:t>
            </a:r>
            <a:r>
              <a:rPr lang="en-US" sz="1200" baseline="30000" dirty="0">
                <a:effectLst/>
                <a:latin typeface="Times New Roman" panose="02020603050405020304" pitchFamily="18" charset="0"/>
                <a:ea typeface="Times New Roman" panose="02020603050405020304" pitchFamily="18" charset="0"/>
              </a:rPr>
              <a:t>2+</a:t>
            </a:r>
            <a:r>
              <a:rPr lang="en-US" sz="1200" dirty="0">
                <a:effectLst/>
                <a:latin typeface="Times New Roman" panose="02020603050405020304" pitchFamily="18" charset="0"/>
                <a:ea typeface="Times New Roman" panose="02020603050405020304" pitchFamily="18" charset="0"/>
              </a:rPr>
              <a:t> recordings. ΔF/F0 represents the ratio between the maximum fluorescence change during the stimulus (Fmax) and the baseline fluorescence before the stimulus (F0). T50 was defined as the time interval between the peak value and the time at which the signal decayed to 50% of peak amplitude. The AUC representing the area between F0 to 50% recovery of the calcium signal, is a measure of the overall amount of calcium that entered the cell. The decay slope, measured from the peak amplitude to the time at which the signal decayed to 50% of peak amplitude, is a measure of calcium kinetics during recovery period.</a:t>
            </a:r>
          </a:p>
        </p:txBody>
      </p:sp>
    </p:spTree>
    <p:extLst>
      <p:ext uri="{BB962C8B-B14F-4D97-AF65-F5344CB8AC3E}">
        <p14:creationId xmlns:p14="http://schemas.microsoft.com/office/powerpoint/2010/main" val="277885153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7</TotalTime>
  <Words>147</Words>
  <Application>Microsoft Office PowerPoint</Application>
  <PresentationFormat>On-screen Show (4:3)</PresentationFormat>
  <Paragraphs>9</Paragraphs>
  <Slides>1</Slides>
  <Notes>1</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7" baseType="lpstr">
      <vt:lpstr>Arial</vt:lpstr>
      <vt:lpstr>Calibri</vt:lpstr>
      <vt:lpstr>Calibri Light</vt:lpstr>
      <vt:lpstr>Times New Roman</vt:lpstr>
      <vt:lpstr>Office Theme</vt:lpstr>
      <vt:lpstr>Prism Project</vt:lpstr>
      <vt:lpstr>PowerPoint Presentation</vt:lpstr>
    </vt:vector>
  </TitlesOfParts>
  <Company>UNI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exandru Florian Deftu</dc:creator>
  <cp:lastModifiedBy>MDPI</cp:lastModifiedBy>
  <cp:revision>48</cp:revision>
  <cp:lastPrinted>2021-02-11T11:13:25Z</cp:lastPrinted>
  <dcterms:created xsi:type="dcterms:W3CDTF">2019-06-13T17:46:39Z</dcterms:created>
  <dcterms:modified xsi:type="dcterms:W3CDTF">2023-10-31T07:30:59Z</dcterms:modified>
</cp:coreProperties>
</file>